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1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sldIdLst>
    <p:sldId id="262" r:id="rId2"/>
    <p:sldId id="263" r:id="rId3"/>
    <p:sldId id="264" r:id="rId4"/>
    <p:sldId id="265" r:id="rId5"/>
    <p:sldId id="266" r:id="rId6"/>
    <p:sldId id="268" r:id="rId7"/>
    <p:sldId id="267" r:id="rId8"/>
  </p:sldIdLst>
  <p:sldSz cx="14711363" cy="10817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E02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3447" autoAdjust="0"/>
  </p:normalViewPr>
  <p:slideViewPr>
    <p:cSldViewPr snapToGrid="0">
      <p:cViewPr varScale="1">
        <p:scale>
          <a:sx n="52" d="100"/>
          <a:sy n="52" d="100"/>
        </p:scale>
        <p:origin x="1464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yumi\Desktop\JGOG1072S-A2&#35299;&#26512;&#12487;&#12540;&#12479;\&#20013;&#12522;&#12473;&#12463;Figs\0819_Figure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yumi\Desktop\JGOG1072S-A2&#35299;&#26512;&#12487;&#12540;&#12479;\&#20013;&#12522;&#12473;&#12463;Figs\0819_Figure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yumi\Desktop\JGOG1072S-A2&#35299;&#26512;&#12487;&#12540;&#12479;\0829_results&#20013;&#12522;&#12473;&#12463;&#35542;&#25991;&#20351;&#29992;\0829_riskfactor&#27598;&#12398;&#20998;&#24067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yumi\Desktop\JGOG1072S-A2&#35299;&#26512;&#12487;&#12540;&#12479;\Figs\&#12510;&#12483;&#12481;&#12531;&#12464;&#24460;&#12398;&#12522;&#12473;&#12463;&#22240;&#23376;&#12398;&#25968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yumi\Desktop\JGOG1072S-A2&#35299;&#26512;&#12487;&#12540;&#12479;\Figs\&#12510;&#12483;&#12481;&#12531;&#12464;&#24460;&#12398;&#12522;&#12473;&#12463;&#22240;&#23376;&#12398;&#25968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yumi\Desktop\JGOG1072S-A2&#35299;&#26512;&#12487;&#12540;&#12479;\Figs\&#12510;&#12483;&#12481;&#12531;&#12464;&#24460;&#12398;&#12522;&#12473;&#12463;&#22240;&#23376;&#12398;&#25968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yumi\Desktop\JGOG1072S-A2&#35299;&#26512;&#12487;&#12540;&#12479;\Figs\&#12510;&#12483;&#12481;&#12531;&#12464;&#24460;&#12398;&#12522;&#12473;&#12463;&#22240;&#23376;&#12398;&#25968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yumi\Desktop\&#12469;&#12452;&#12474;&#12395;&#12424;&#12427;&#12522;&#12473;&#12463;&#22240;&#23376;&#12398;&#25968;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yumi\Desktop\&#12469;&#12452;&#12474;&#12395;&#12424;&#12427;&#12522;&#12473;&#12463;&#22240;&#23376;&#12398;&#25968;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2400" b="1"/>
              <a:t>Treatment selection</a:t>
            </a:r>
            <a:endParaRPr lang="ja-JP" sz="2400" b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Figure2A!$B$1</c:f>
              <c:strCache>
                <c:ptCount val="1"/>
                <c:pt idx="0">
                  <c:v>non-treatme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igure2A!$A$2:$A$3</c:f>
              <c:strCache>
                <c:ptCount val="2"/>
                <c:pt idx="0">
                  <c:v>high volume</c:v>
                </c:pt>
                <c:pt idx="1">
                  <c:v>non-high volume</c:v>
                </c:pt>
              </c:strCache>
            </c:strRef>
          </c:cat>
          <c:val>
            <c:numRef>
              <c:f>Figure2A!$B$2:$B$3</c:f>
              <c:numCache>
                <c:formatCode>General</c:formatCode>
                <c:ptCount val="2"/>
                <c:pt idx="0">
                  <c:v>215</c:v>
                </c:pt>
                <c:pt idx="1">
                  <c:v>4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23-4D96-926E-4EE143A63CBF}"/>
            </c:ext>
          </c:extLst>
        </c:ser>
        <c:ser>
          <c:idx val="1"/>
          <c:order val="1"/>
          <c:tx>
            <c:strRef>
              <c:f>Figure2A!$C$1</c:f>
              <c:strCache>
                <c:ptCount val="1"/>
                <c:pt idx="0">
                  <c:v>Chemotherapy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Figure2A!$A$2:$A$3</c:f>
              <c:strCache>
                <c:ptCount val="2"/>
                <c:pt idx="0">
                  <c:v>high volume</c:v>
                </c:pt>
                <c:pt idx="1">
                  <c:v>non-high volume</c:v>
                </c:pt>
              </c:strCache>
            </c:strRef>
          </c:cat>
          <c:val>
            <c:numRef>
              <c:f>Figure2A!$C$2:$C$3</c:f>
              <c:numCache>
                <c:formatCode>General</c:formatCode>
                <c:ptCount val="2"/>
                <c:pt idx="0">
                  <c:v>74</c:v>
                </c:pt>
                <c:pt idx="1">
                  <c:v>2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B23-4D96-926E-4EE143A63CBF}"/>
            </c:ext>
          </c:extLst>
        </c:ser>
        <c:ser>
          <c:idx val="2"/>
          <c:order val="2"/>
          <c:tx>
            <c:strRef>
              <c:f>Figure2A!$D$1</c:f>
              <c:strCache>
                <c:ptCount val="1"/>
                <c:pt idx="0">
                  <c:v>Radiation</c:v>
                </c:pt>
              </c:strCache>
            </c:strRef>
          </c:tx>
          <c:spPr>
            <a:solidFill>
              <a:srgbClr val="FF7C80"/>
            </a:solidFill>
            <a:ln>
              <a:noFill/>
            </a:ln>
            <a:effectLst/>
          </c:spPr>
          <c:invertIfNegative val="0"/>
          <c:cat>
            <c:strRef>
              <c:f>Figure2A!$A$2:$A$3</c:f>
              <c:strCache>
                <c:ptCount val="2"/>
                <c:pt idx="0">
                  <c:v>high volume</c:v>
                </c:pt>
                <c:pt idx="1">
                  <c:v>non-high volume</c:v>
                </c:pt>
              </c:strCache>
            </c:strRef>
          </c:cat>
          <c:val>
            <c:numRef>
              <c:f>Figure2A!$D$2:$D$3</c:f>
              <c:numCache>
                <c:formatCode>General</c:formatCode>
                <c:ptCount val="2"/>
                <c:pt idx="0">
                  <c:v>100</c:v>
                </c:pt>
                <c:pt idx="1">
                  <c:v>2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B23-4D96-926E-4EE143A63CBF}"/>
            </c:ext>
          </c:extLst>
        </c:ser>
        <c:ser>
          <c:idx val="3"/>
          <c:order val="3"/>
          <c:tx>
            <c:strRef>
              <c:f>Figure2A!$E$1</c:f>
              <c:strCache>
                <c:ptCount val="1"/>
                <c:pt idx="0">
                  <c:v>CR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Figure2A!$A$2:$A$3</c:f>
              <c:strCache>
                <c:ptCount val="2"/>
                <c:pt idx="0">
                  <c:v>high volume</c:v>
                </c:pt>
                <c:pt idx="1">
                  <c:v>non-high volume</c:v>
                </c:pt>
              </c:strCache>
            </c:strRef>
          </c:cat>
          <c:val>
            <c:numRef>
              <c:f>Figure2A!$E$2:$E$3</c:f>
              <c:numCache>
                <c:formatCode>General</c:formatCode>
                <c:ptCount val="2"/>
                <c:pt idx="0">
                  <c:v>104</c:v>
                </c:pt>
                <c:pt idx="1">
                  <c:v>2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B23-4D96-926E-4EE143A63C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59474927"/>
        <c:axId val="1459475343"/>
      </c:barChart>
      <c:catAx>
        <c:axId val="14594749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59475343"/>
        <c:crosses val="autoZero"/>
        <c:auto val="1"/>
        <c:lblAlgn val="ctr"/>
        <c:lblOffset val="100"/>
        <c:noMultiLvlLbl val="0"/>
      </c:catAx>
      <c:valAx>
        <c:axId val="145947534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59474927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2400" b="1"/>
              <a:t>Treatment selection</a:t>
            </a:r>
            <a:endParaRPr lang="ja-JP" sz="2400" b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Figure2B!$C$1</c:f>
              <c:strCache>
                <c:ptCount val="1"/>
                <c:pt idx="0">
                  <c:v>Non-treatme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igure2B!$B$2:$B$11</c:f>
              <c:strCache>
                <c:ptCount val="10"/>
                <c:pt idx="0">
                  <c:v>H01</c:v>
                </c:pt>
                <c:pt idx="1">
                  <c:v>H02</c:v>
                </c:pt>
                <c:pt idx="2">
                  <c:v>H03</c:v>
                </c:pt>
                <c:pt idx="3">
                  <c:v>H04</c:v>
                </c:pt>
                <c:pt idx="4">
                  <c:v>H05</c:v>
                </c:pt>
                <c:pt idx="5">
                  <c:v>H06</c:v>
                </c:pt>
                <c:pt idx="6">
                  <c:v>H07</c:v>
                </c:pt>
                <c:pt idx="7">
                  <c:v>H08</c:v>
                </c:pt>
                <c:pt idx="8">
                  <c:v>H09</c:v>
                </c:pt>
                <c:pt idx="9">
                  <c:v>H10</c:v>
                </c:pt>
              </c:strCache>
            </c:strRef>
          </c:cat>
          <c:val>
            <c:numRef>
              <c:f>Figure2B!$C$2:$C$11</c:f>
              <c:numCache>
                <c:formatCode>General</c:formatCode>
                <c:ptCount val="10"/>
                <c:pt idx="0">
                  <c:v>43</c:v>
                </c:pt>
                <c:pt idx="1">
                  <c:v>34</c:v>
                </c:pt>
                <c:pt idx="2">
                  <c:v>29</c:v>
                </c:pt>
                <c:pt idx="3">
                  <c:v>30</c:v>
                </c:pt>
                <c:pt idx="4">
                  <c:v>18</c:v>
                </c:pt>
                <c:pt idx="5">
                  <c:v>27</c:v>
                </c:pt>
                <c:pt idx="6">
                  <c:v>17</c:v>
                </c:pt>
                <c:pt idx="7">
                  <c:v>6</c:v>
                </c:pt>
                <c:pt idx="8">
                  <c:v>1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AB-44FE-ACEA-B4A219019F68}"/>
            </c:ext>
          </c:extLst>
        </c:ser>
        <c:ser>
          <c:idx val="1"/>
          <c:order val="1"/>
          <c:tx>
            <c:strRef>
              <c:f>Figure2B!$D$1</c:f>
              <c:strCache>
                <c:ptCount val="1"/>
                <c:pt idx="0">
                  <c:v>Chemotherapy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Figure2B!$B$2:$B$11</c:f>
              <c:strCache>
                <c:ptCount val="10"/>
                <c:pt idx="0">
                  <c:v>H01</c:v>
                </c:pt>
                <c:pt idx="1">
                  <c:v>H02</c:v>
                </c:pt>
                <c:pt idx="2">
                  <c:v>H03</c:v>
                </c:pt>
                <c:pt idx="3">
                  <c:v>H04</c:v>
                </c:pt>
                <c:pt idx="4">
                  <c:v>H05</c:v>
                </c:pt>
                <c:pt idx="5">
                  <c:v>H06</c:v>
                </c:pt>
                <c:pt idx="6">
                  <c:v>H07</c:v>
                </c:pt>
                <c:pt idx="7">
                  <c:v>H08</c:v>
                </c:pt>
                <c:pt idx="8">
                  <c:v>H09</c:v>
                </c:pt>
                <c:pt idx="9">
                  <c:v>H10</c:v>
                </c:pt>
              </c:strCache>
            </c:strRef>
          </c:cat>
          <c:val>
            <c:numRef>
              <c:f>Figure2B!$D$2:$D$11</c:f>
              <c:numCache>
                <c:formatCode>General</c:formatCode>
                <c:ptCount val="10"/>
                <c:pt idx="0">
                  <c:v>7</c:v>
                </c:pt>
                <c:pt idx="1">
                  <c:v>38</c:v>
                </c:pt>
                <c:pt idx="2">
                  <c:v>4</c:v>
                </c:pt>
                <c:pt idx="3">
                  <c:v>1</c:v>
                </c:pt>
                <c:pt idx="4">
                  <c:v>18</c:v>
                </c:pt>
                <c:pt idx="5">
                  <c:v>1</c:v>
                </c:pt>
                <c:pt idx="6">
                  <c:v>4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7AB-44FE-ACEA-B4A219019F68}"/>
            </c:ext>
          </c:extLst>
        </c:ser>
        <c:ser>
          <c:idx val="2"/>
          <c:order val="2"/>
          <c:tx>
            <c:strRef>
              <c:f>Figure2B!$E$1</c:f>
              <c:strCache>
                <c:ptCount val="1"/>
                <c:pt idx="0">
                  <c:v>Radiation</c:v>
                </c:pt>
              </c:strCache>
            </c:strRef>
          </c:tx>
          <c:spPr>
            <a:solidFill>
              <a:srgbClr val="FF7C80"/>
            </a:solidFill>
            <a:ln>
              <a:noFill/>
            </a:ln>
            <a:effectLst/>
          </c:spPr>
          <c:invertIfNegative val="0"/>
          <c:cat>
            <c:strRef>
              <c:f>Figure2B!$B$2:$B$11</c:f>
              <c:strCache>
                <c:ptCount val="10"/>
                <c:pt idx="0">
                  <c:v>H01</c:v>
                </c:pt>
                <c:pt idx="1">
                  <c:v>H02</c:v>
                </c:pt>
                <c:pt idx="2">
                  <c:v>H03</c:v>
                </c:pt>
                <c:pt idx="3">
                  <c:v>H04</c:v>
                </c:pt>
                <c:pt idx="4">
                  <c:v>H05</c:v>
                </c:pt>
                <c:pt idx="5">
                  <c:v>H06</c:v>
                </c:pt>
                <c:pt idx="6">
                  <c:v>H07</c:v>
                </c:pt>
                <c:pt idx="7">
                  <c:v>H08</c:v>
                </c:pt>
                <c:pt idx="8">
                  <c:v>H09</c:v>
                </c:pt>
                <c:pt idx="9">
                  <c:v>H10</c:v>
                </c:pt>
              </c:strCache>
            </c:strRef>
          </c:cat>
          <c:val>
            <c:numRef>
              <c:f>Figure2B!$E$2:$E$11</c:f>
              <c:numCache>
                <c:formatCode>General</c:formatCode>
                <c:ptCount val="10"/>
                <c:pt idx="0">
                  <c:v>15</c:v>
                </c:pt>
                <c:pt idx="1">
                  <c:v>2</c:v>
                </c:pt>
                <c:pt idx="2">
                  <c:v>11</c:v>
                </c:pt>
                <c:pt idx="3">
                  <c:v>0</c:v>
                </c:pt>
                <c:pt idx="4">
                  <c:v>1</c:v>
                </c:pt>
                <c:pt idx="5">
                  <c:v>9</c:v>
                </c:pt>
                <c:pt idx="6">
                  <c:v>11</c:v>
                </c:pt>
                <c:pt idx="7">
                  <c:v>25</c:v>
                </c:pt>
                <c:pt idx="8">
                  <c:v>20</c:v>
                </c:pt>
                <c:pt idx="9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7AB-44FE-ACEA-B4A219019F68}"/>
            </c:ext>
          </c:extLst>
        </c:ser>
        <c:ser>
          <c:idx val="3"/>
          <c:order val="3"/>
          <c:tx>
            <c:strRef>
              <c:f>Figure2B!$F$1</c:f>
              <c:strCache>
                <c:ptCount val="1"/>
                <c:pt idx="0">
                  <c:v>CR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Figure2B!$B$2:$B$11</c:f>
              <c:strCache>
                <c:ptCount val="10"/>
                <c:pt idx="0">
                  <c:v>H01</c:v>
                </c:pt>
                <c:pt idx="1">
                  <c:v>H02</c:v>
                </c:pt>
                <c:pt idx="2">
                  <c:v>H03</c:v>
                </c:pt>
                <c:pt idx="3">
                  <c:v>H04</c:v>
                </c:pt>
                <c:pt idx="4">
                  <c:v>H05</c:v>
                </c:pt>
                <c:pt idx="5">
                  <c:v>H06</c:v>
                </c:pt>
                <c:pt idx="6">
                  <c:v>H07</c:v>
                </c:pt>
                <c:pt idx="7">
                  <c:v>H08</c:v>
                </c:pt>
                <c:pt idx="8">
                  <c:v>H09</c:v>
                </c:pt>
                <c:pt idx="9">
                  <c:v>H10</c:v>
                </c:pt>
              </c:strCache>
            </c:strRef>
          </c:cat>
          <c:val>
            <c:numRef>
              <c:f>Figure2B!$F$2:$F$11</c:f>
              <c:numCache>
                <c:formatCode>General</c:formatCode>
                <c:ptCount val="10"/>
                <c:pt idx="0">
                  <c:v>10</c:v>
                </c:pt>
                <c:pt idx="1">
                  <c:v>0</c:v>
                </c:pt>
                <c:pt idx="2">
                  <c:v>23</c:v>
                </c:pt>
                <c:pt idx="3">
                  <c:v>34</c:v>
                </c:pt>
                <c:pt idx="4">
                  <c:v>13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7AB-44FE-ACEA-B4A219019F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15620831"/>
        <c:axId val="1515620415"/>
      </c:barChart>
      <c:catAx>
        <c:axId val="151562083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15620415"/>
        <c:crosses val="autoZero"/>
        <c:auto val="1"/>
        <c:lblAlgn val="ctr"/>
        <c:lblOffset val="100"/>
        <c:noMultiLvlLbl val="0"/>
      </c:catAx>
      <c:valAx>
        <c:axId val="151562041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15620831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Non-treatme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C$2:$E$2</c:f>
              <c:strCache>
                <c:ptCount val="3"/>
                <c:pt idx="0">
                  <c:v>one factor</c:v>
                </c:pt>
                <c:pt idx="1">
                  <c:v>two factors</c:v>
                </c:pt>
                <c:pt idx="2">
                  <c:v>three factors</c:v>
                </c:pt>
              </c:strCache>
            </c:strRef>
          </c:cat>
          <c:val>
            <c:numRef>
              <c:f>Sheet1!$C$3:$E$3</c:f>
              <c:numCache>
                <c:formatCode>General</c:formatCode>
                <c:ptCount val="3"/>
                <c:pt idx="0">
                  <c:v>437</c:v>
                </c:pt>
                <c:pt idx="1">
                  <c:v>159</c:v>
                </c:pt>
                <c:pt idx="2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DC-4A63-9949-A9C39056CF08}"/>
            </c:ext>
          </c:extLst>
        </c:ser>
        <c:ser>
          <c:idx val="1"/>
          <c:order val="1"/>
          <c:tx>
            <c:strRef>
              <c:f>Sheet1!$B$4</c:f>
              <c:strCache>
                <c:ptCount val="1"/>
                <c:pt idx="0">
                  <c:v>Chemotherapy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1!$C$2:$E$2</c:f>
              <c:strCache>
                <c:ptCount val="3"/>
                <c:pt idx="0">
                  <c:v>one factor</c:v>
                </c:pt>
                <c:pt idx="1">
                  <c:v>two factors</c:v>
                </c:pt>
                <c:pt idx="2">
                  <c:v>three factors</c:v>
                </c:pt>
              </c:strCache>
            </c:strRef>
          </c:cat>
          <c:val>
            <c:numRef>
              <c:f>Sheet1!$C$4:$E$4</c:f>
              <c:numCache>
                <c:formatCode>General</c:formatCode>
                <c:ptCount val="3"/>
                <c:pt idx="0">
                  <c:v>137</c:v>
                </c:pt>
                <c:pt idx="1">
                  <c:v>153</c:v>
                </c:pt>
                <c:pt idx="2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BDC-4A63-9949-A9C39056CF08}"/>
            </c:ext>
          </c:extLst>
        </c:ser>
        <c:ser>
          <c:idx val="2"/>
          <c:order val="2"/>
          <c:tx>
            <c:strRef>
              <c:f>Sheet1!$B$5</c:f>
              <c:strCache>
                <c:ptCount val="1"/>
                <c:pt idx="0">
                  <c:v>Radiation</c:v>
                </c:pt>
              </c:strCache>
            </c:strRef>
          </c:tx>
          <c:spPr>
            <a:solidFill>
              <a:srgbClr val="FF7C80"/>
            </a:solidFill>
            <a:ln>
              <a:noFill/>
            </a:ln>
            <a:effectLst/>
          </c:spPr>
          <c:invertIfNegative val="0"/>
          <c:cat>
            <c:strRef>
              <c:f>Sheet1!$C$2:$E$2</c:f>
              <c:strCache>
                <c:ptCount val="3"/>
                <c:pt idx="0">
                  <c:v>one factor</c:v>
                </c:pt>
                <c:pt idx="1">
                  <c:v>two factors</c:v>
                </c:pt>
                <c:pt idx="2">
                  <c:v>three factors</c:v>
                </c:pt>
              </c:strCache>
            </c:strRef>
          </c:cat>
          <c:val>
            <c:numRef>
              <c:f>Sheet1!$C$5:$E$5</c:f>
              <c:numCache>
                <c:formatCode>General</c:formatCode>
                <c:ptCount val="3"/>
                <c:pt idx="0">
                  <c:v>101</c:v>
                </c:pt>
                <c:pt idx="1">
                  <c:v>146</c:v>
                </c:pt>
                <c:pt idx="2">
                  <c:v>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BDC-4A63-9949-A9C39056CF08}"/>
            </c:ext>
          </c:extLst>
        </c:ser>
        <c:ser>
          <c:idx val="3"/>
          <c:order val="3"/>
          <c:tx>
            <c:strRef>
              <c:f>Sheet1!$B$6</c:f>
              <c:strCache>
                <c:ptCount val="1"/>
                <c:pt idx="0">
                  <c:v>CR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Sheet1!$C$2:$E$2</c:f>
              <c:strCache>
                <c:ptCount val="3"/>
                <c:pt idx="0">
                  <c:v>one factor</c:v>
                </c:pt>
                <c:pt idx="1">
                  <c:v>two factors</c:v>
                </c:pt>
                <c:pt idx="2">
                  <c:v>three factors</c:v>
                </c:pt>
              </c:strCache>
            </c:strRef>
          </c:cat>
          <c:val>
            <c:numRef>
              <c:f>Sheet1!$C$6:$E$6</c:f>
              <c:numCache>
                <c:formatCode>General</c:formatCode>
                <c:ptCount val="3"/>
                <c:pt idx="0">
                  <c:v>90</c:v>
                </c:pt>
                <c:pt idx="1">
                  <c:v>158</c:v>
                </c:pt>
                <c:pt idx="2">
                  <c:v>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BDC-4A63-9949-A9C39056CF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90600527"/>
        <c:axId val="1490594287"/>
      </c:barChart>
      <c:catAx>
        <c:axId val="14906005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90594287"/>
        <c:crosses val="autoZero"/>
        <c:auto val="1"/>
        <c:lblAlgn val="ctr"/>
        <c:lblOffset val="100"/>
        <c:noMultiLvlLbl val="0"/>
      </c:catAx>
      <c:valAx>
        <c:axId val="149059428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90600527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E$2</c:f>
              <c:strCache>
                <c:ptCount val="1"/>
                <c:pt idx="0">
                  <c:v>Non-treatmen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A92-4444-876A-40E120B10DF3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A92-4444-876A-40E120B10DF3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A92-4444-876A-40E120B10DF3}"/>
              </c:ext>
            </c:extLst>
          </c:dPt>
          <c:cat>
            <c:strRef>
              <c:f>Sheet1!$D$3:$D$5</c:f>
              <c:strCache>
                <c:ptCount val="3"/>
                <c:pt idx="0">
                  <c:v>one factor</c:v>
                </c:pt>
                <c:pt idx="1">
                  <c:v>two factors</c:v>
                </c:pt>
                <c:pt idx="2">
                  <c:v>three factors</c:v>
                </c:pt>
              </c:strCache>
            </c:strRef>
          </c:cat>
          <c:val>
            <c:numRef>
              <c:f>Sheet1!$E$3:$E$5</c:f>
              <c:numCache>
                <c:formatCode>General</c:formatCode>
                <c:ptCount val="3"/>
                <c:pt idx="0">
                  <c:v>293</c:v>
                </c:pt>
                <c:pt idx="1">
                  <c:v>155</c:v>
                </c:pt>
                <c:pt idx="2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A92-4444-876A-40E120B10D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1"/>
          <c:order val="1"/>
          <c:tx>
            <c:strRef>
              <c:f>Sheet1!$F$2</c:f>
              <c:strCache>
                <c:ptCount val="1"/>
                <c:pt idx="0">
                  <c:v>Treatmen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61C-4EEC-B5E6-0C1D3FE7B7F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61C-4EEC-B5E6-0C1D3FE7B7F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61C-4EEC-B5E6-0C1D3FE7B7FE}"/>
              </c:ext>
            </c:extLst>
          </c:dPt>
          <c:cat>
            <c:strRef>
              <c:f>Sheet1!$D$3:$D$5</c:f>
              <c:strCache>
                <c:ptCount val="3"/>
                <c:pt idx="0">
                  <c:v>one factor</c:v>
                </c:pt>
                <c:pt idx="1">
                  <c:v>two factors</c:v>
                </c:pt>
                <c:pt idx="2">
                  <c:v>three factors</c:v>
                </c:pt>
              </c:strCache>
            </c:strRef>
          </c:cat>
          <c:val>
            <c:numRef>
              <c:f>Sheet1!$F$3:$F$5</c:f>
              <c:numCache>
                <c:formatCode>General</c:formatCode>
                <c:ptCount val="3"/>
                <c:pt idx="0">
                  <c:v>295</c:v>
                </c:pt>
                <c:pt idx="1">
                  <c:v>152</c:v>
                </c:pt>
                <c:pt idx="2">
                  <c:v>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61C-4EEC-B5E6-0C1D3FE7B7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extLst>
          <c:ext xmlns:c15="http://schemas.microsoft.com/office/drawing/2012/chart" uri="{02D57815-91ED-43cb-92C2-25804820EDAC}">
            <c15:filteredPi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heet1!$E$2</c15:sqref>
                        </c15:formulaRef>
                      </c:ext>
                    </c:extLst>
                    <c:strCache>
                      <c:ptCount val="1"/>
                      <c:pt idx="0">
                        <c:v>Non-treatment</c:v>
                      </c:pt>
                    </c:strCache>
                  </c:strRef>
                </c:tx>
                <c:dPt>
                  <c:idx val="0"/>
                  <c:bubble3D val="0"/>
                  <c:spPr>
                    <a:solidFill>
                      <a:schemeClr val="accent1"/>
                    </a:solidFill>
                    <a:ln w="19050">
                      <a:solidFill>
                        <a:schemeClr val="lt1"/>
                      </a:solidFill>
                    </a:ln>
                    <a:effectLst/>
                  </c:spPr>
                  <c:extLst>
                    <c:ext xmlns:c16="http://schemas.microsoft.com/office/drawing/2014/chart" uri="{C3380CC4-5D6E-409C-BE32-E72D297353CC}">
                      <c16:uniqueId val="{00000008-961C-4EEC-B5E6-0C1D3FE7B7FE}"/>
                    </c:ext>
                  </c:extLst>
                </c:dPt>
                <c:dPt>
                  <c:idx val="1"/>
                  <c:bubble3D val="0"/>
                  <c:spPr>
                    <a:solidFill>
                      <a:schemeClr val="accent2"/>
                    </a:solidFill>
                    <a:ln w="19050">
                      <a:solidFill>
                        <a:schemeClr val="lt1"/>
                      </a:solidFill>
                    </a:ln>
                    <a:effectLst/>
                  </c:spPr>
                  <c:extLst>
                    <c:ext xmlns:c16="http://schemas.microsoft.com/office/drawing/2014/chart" uri="{C3380CC4-5D6E-409C-BE32-E72D297353CC}">
                      <c16:uniqueId val="{0000000A-961C-4EEC-B5E6-0C1D3FE7B7FE}"/>
                    </c:ext>
                  </c:extLst>
                </c:dPt>
                <c:dPt>
                  <c:idx val="2"/>
                  <c:bubble3D val="0"/>
                  <c:spPr>
                    <a:solidFill>
                      <a:schemeClr val="accent3"/>
                    </a:solidFill>
                    <a:ln w="19050">
                      <a:solidFill>
                        <a:schemeClr val="lt1"/>
                      </a:solidFill>
                    </a:ln>
                    <a:effectLst/>
                  </c:spPr>
                  <c:extLst>
                    <c:ext xmlns:c16="http://schemas.microsoft.com/office/drawing/2014/chart" uri="{C3380CC4-5D6E-409C-BE32-E72D297353CC}">
                      <c16:uniqueId val="{0000000C-961C-4EEC-B5E6-0C1D3FE7B7FE}"/>
                    </c:ext>
                  </c:extLst>
                </c:dPt>
                <c:cat>
                  <c:strRef>
                    <c:extLst>
                      <c:ext uri="{02D57815-91ED-43cb-92C2-25804820EDAC}">
                        <c15:formulaRef>
                          <c15:sqref>Sheet1!$D$3:$D$5</c15:sqref>
                        </c15:formulaRef>
                      </c:ext>
                    </c:extLst>
                    <c:strCache>
                      <c:ptCount val="3"/>
                      <c:pt idx="0">
                        <c:v>one factor</c:v>
                      </c:pt>
                      <c:pt idx="1">
                        <c:v>two factors</c:v>
                      </c:pt>
                      <c:pt idx="2">
                        <c:v>three factors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heet1!$E$3:$E$5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293</c:v>
                      </c:pt>
                      <c:pt idx="1">
                        <c:v>155</c:v>
                      </c:pt>
                      <c:pt idx="2">
                        <c:v>32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D-961C-4EEC-B5E6-0C1D3FE7B7FE}"/>
                  </c:ext>
                </c:extLst>
              </c15:ser>
            </c15:filteredPieSeries>
          </c:ext>
        </c:extLst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dirty="0"/>
              <a:t>Radia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E$8</c:f>
              <c:strCache>
                <c:ptCount val="1"/>
                <c:pt idx="0">
                  <c:v>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3DC-4B9A-8B61-2DCFE25466C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3DC-4B9A-8B61-2DCFE25466C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3DC-4B9A-8B61-2DCFE25466C4}"/>
              </c:ext>
            </c:extLst>
          </c:dPt>
          <c:cat>
            <c:strRef>
              <c:f>Sheet1!$D$9:$D$11</c:f>
              <c:strCache>
                <c:ptCount val="3"/>
                <c:pt idx="0">
                  <c:v>one factor</c:v>
                </c:pt>
                <c:pt idx="1">
                  <c:v>two factors</c:v>
                </c:pt>
                <c:pt idx="2">
                  <c:v>three factors</c:v>
                </c:pt>
              </c:strCache>
            </c:strRef>
          </c:cat>
          <c:val>
            <c:numRef>
              <c:f>Sheet1!$E$9:$E$11</c:f>
              <c:numCache>
                <c:formatCode>General</c:formatCode>
                <c:ptCount val="3"/>
                <c:pt idx="0">
                  <c:v>121</c:v>
                </c:pt>
                <c:pt idx="1">
                  <c:v>142</c:v>
                </c:pt>
                <c:pt idx="2">
                  <c:v>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3DC-4B9A-8B61-2DCFE25466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dirty="0"/>
              <a:t>Chemotherapy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1"/>
          <c:order val="1"/>
          <c:tx>
            <c:strRef>
              <c:f>Sheet1!$F$8</c:f>
              <c:strCache>
                <c:ptCount val="1"/>
                <c:pt idx="0">
                  <c:v>C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544-4B32-87E6-AF232FDF09D5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544-4B32-87E6-AF232FDF09D5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544-4B32-87E6-AF232FDF09D5}"/>
              </c:ext>
            </c:extLst>
          </c:dPt>
          <c:cat>
            <c:strRef>
              <c:f>Sheet1!$D$9:$D$11</c:f>
              <c:strCache>
                <c:ptCount val="3"/>
                <c:pt idx="0">
                  <c:v>one factor</c:v>
                </c:pt>
                <c:pt idx="1">
                  <c:v>two factors</c:v>
                </c:pt>
                <c:pt idx="2">
                  <c:v>three factors</c:v>
                </c:pt>
              </c:strCache>
            </c:strRef>
          </c:cat>
          <c:val>
            <c:numRef>
              <c:f>Sheet1!$F$9:$F$11</c:f>
              <c:numCache>
                <c:formatCode>General</c:formatCode>
                <c:ptCount val="3"/>
                <c:pt idx="0">
                  <c:v>122</c:v>
                </c:pt>
                <c:pt idx="1">
                  <c:v>141</c:v>
                </c:pt>
                <c:pt idx="2">
                  <c:v>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544-4B32-87E6-AF232FDF09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extLst>
          <c:ext xmlns:c15="http://schemas.microsoft.com/office/drawing/2012/chart" uri="{02D57815-91ED-43cb-92C2-25804820EDAC}">
            <c15:filteredPi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heet1!$E$8</c15:sqref>
                        </c15:formulaRef>
                      </c:ext>
                    </c:extLst>
                    <c:strCache>
                      <c:ptCount val="1"/>
                      <c:pt idx="0">
                        <c:v>RT</c:v>
                      </c:pt>
                    </c:strCache>
                  </c:strRef>
                </c:tx>
                <c:dPt>
                  <c:idx val="0"/>
                  <c:bubble3D val="0"/>
                  <c:spPr>
                    <a:solidFill>
                      <a:schemeClr val="accent1"/>
                    </a:solidFill>
                    <a:ln w="19050">
                      <a:solidFill>
                        <a:schemeClr val="lt1"/>
                      </a:solidFill>
                    </a:ln>
                    <a:effectLst/>
                  </c:spPr>
                  <c:extLst>
                    <c:ext xmlns:c16="http://schemas.microsoft.com/office/drawing/2014/chart" uri="{C3380CC4-5D6E-409C-BE32-E72D297353CC}">
                      <c16:uniqueId val="{00000008-E544-4B32-87E6-AF232FDF09D5}"/>
                    </c:ext>
                  </c:extLst>
                </c:dPt>
                <c:dPt>
                  <c:idx val="1"/>
                  <c:bubble3D val="0"/>
                  <c:spPr>
                    <a:solidFill>
                      <a:schemeClr val="accent2"/>
                    </a:solidFill>
                    <a:ln w="19050">
                      <a:solidFill>
                        <a:schemeClr val="lt1"/>
                      </a:solidFill>
                    </a:ln>
                    <a:effectLst/>
                  </c:spPr>
                  <c:extLst>
                    <c:ext xmlns:c16="http://schemas.microsoft.com/office/drawing/2014/chart" uri="{C3380CC4-5D6E-409C-BE32-E72D297353CC}">
                      <c16:uniqueId val="{0000000A-E544-4B32-87E6-AF232FDF09D5}"/>
                    </c:ext>
                  </c:extLst>
                </c:dPt>
                <c:dPt>
                  <c:idx val="2"/>
                  <c:bubble3D val="0"/>
                  <c:spPr>
                    <a:solidFill>
                      <a:schemeClr val="accent3"/>
                    </a:solidFill>
                    <a:ln w="19050">
                      <a:solidFill>
                        <a:schemeClr val="lt1"/>
                      </a:solidFill>
                    </a:ln>
                    <a:effectLst/>
                  </c:spPr>
                  <c:extLst>
                    <c:ext xmlns:c16="http://schemas.microsoft.com/office/drawing/2014/chart" uri="{C3380CC4-5D6E-409C-BE32-E72D297353CC}">
                      <c16:uniqueId val="{0000000C-E544-4B32-87E6-AF232FDF09D5}"/>
                    </c:ext>
                  </c:extLst>
                </c:dPt>
                <c:cat>
                  <c:strRef>
                    <c:extLst>
                      <c:ext uri="{02D57815-91ED-43cb-92C2-25804820EDAC}">
                        <c15:formulaRef>
                          <c15:sqref>Sheet1!$D$9:$D$11</c15:sqref>
                        </c15:formulaRef>
                      </c:ext>
                    </c:extLst>
                    <c:strCache>
                      <c:ptCount val="3"/>
                      <c:pt idx="0">
                        <c:v>one factor</c:v>
                      </c:pt>
                      <c:pt idx="1">
                        <c:v>two factors</c:v>
                      </c:pt>
                      <c:pt idx="2">
                        <c:v>three factors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heet1!$E$9:$E$11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121</c:v>
                      </c:pt>
                      <c:pt idx="1">
                        <c:v>142</c:v>
                      </c:pt>
                      <c:pt idx="2">
                        <c:v>48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D-E544-4B32-87E6-AF232FDF09D5}"/>
                  </c:ext>
                </c:extLst>
              </c15:ser>
            </c15:filteredPieSeries>
          </c:ext>
        </c:extLst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F$2</c:f>
              <c:strCache>
                <c:ptCount val="1"/>
                <c:pt idx="0">
                  <c:v> ≥ 2cm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6EC-434E-AC53-253BA265D0B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6EC-434E-AC53-253BA265D0B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6EC-434E-AC53-253BA265D0B8}"/>
              </c:ext>
            </c:extLst>
          </c:dPt>
          <c:cat>
            <c:strRef>
              <c:f>Sheet1!$G$1:$I$1</c:f>
              <c:strCache>
                <c:ptCount val="3"/>
                <c:pt idx="0">
                  <c:v>one factor</c:v>
                </c:pt>
                <c:pt idx="1">
                  <c:v>two factors</c:v>
                </c:pt>
                <c:pt idx="2">
                  <c:v>three factors</c:v>
                </c:pt>
              </c:strCache>
            </c:strRef>
          </c:cat>
          <c:val>
            <c:numRef>
              <c:f>Sheet1!$G$2:$I$2</c:f>
              <c:numCache>
                <c:formatCode>General</c:formatCode>
                <c:ptCount val="3"/>
                <c:pt idx="0">
                  <c:v>531</c:v>
                </c:pt>
                <c:pt idx="1">
                  <c:v>559</c:v>
                </c:pt>
                <c:pt idx="2">
                  <c:v>2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6EC-434E-AC53-253BA265D0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A$2</c:f>
              <c:strCache>
                <c:ptCount val="1"/>
                <c:pt idx="0">
                  <c:v>&lt; 2cm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5D2-4E99-A16D-C9E6AA518272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5D2-4E99-A16D-C9E6AA518272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5D2-4E99-A16D-C9E6AA518272}"/>
              </c:ext>
            </c:extLst>
          </c:dPt>
          <c:cat>
            <c:strRef>
              <c:f>Sheet1!$B$1:$D$1</c:f>
              <c:strCache>
                <c:ptCount val="3"/>
                <c:pt idx="0">
                  <c:v>one factor</c:v>
                </c:pt>
                <c:pt idx="1">
                  <c:v>two factors</c:v>
                </c:pt>
                <c:pt idx="2">
                  <c:v>three factors</c:v>
                </c:pt>
              </c:strCache>
            </c:strRef>
          </c:cat>
          <c:val>
            <c:numRef>
              <c:f>Sheet1!$B$2:$D$2</c:f>
              <c:numCache>
                <c:formatCode>General</c:formatCode>
                <c:ptCount val="3"/>
                <c:pt idx="0">
                  <c:v>234</c:v>
                </c:pt>
                <c:pt idx="1">
                  <c:v>57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5D2-4E99-A16D-C9E6AA5182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3E15AD-F953-40B2-8464-27681D65EDC6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30325" y="1143000"/>
            <a:ext cx="41973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007FE7-F27F-4005-8EFF-2DFA3E9B42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18845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007FE7-F27F-4005-8EFF-2DFA3E9B426A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01934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03352" y="1770320"/>
            <a:ext cx="12504659" cy="3765997"/>
          </a:xfrm>
        </p:spPr>
        <p:txBody>
          <a:bodyPr anchor="b"/>
          <a:lstStyle>
            <a:lvl1pPr algn="ctr">
              <a:defRPr sz="946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38921" y="5681548"/>
            <a:ext cx="11033522" cy="2611658"/>
          </a:xfrm>
        </p:spPr>
        <p:txBody>
          <a:bodyPr/>
          <a:lstStyle>
            <a:lvl1pPr marL="0" indent="0" algn="ctr">
              <a:buNone/>
              <a:defRPr sz="3786"/>
            </a:lvl1pPr>
            <a:lvl2pPr marL="721142" indent="0" algn="ctr">
              <a:buNone/>
              <a:defRPr sz="3155"/>
            </a:lvl2pPr>
            <a:lvl3pPr marL="1442283" indent="0" algn="ctr">
              <a:buNone/>
              <a:defRPr sz="2839"/>
            </a:lvl3pPr>
            <a:lvl4pPr marL="2163425" indent="0" algn="ctr">
              <a:buNone/>
              <a:defRPr sz="2524"/>
            </a:lvl4pPr>
            <a:lvl5pPr marL="2884566" indent="0" algn="ctr">
              <a:buNone/>
              <a:defRPr sz="2524"/>
            </a:lvl5pPr>
            <a:lvl6pPr marL="3605708" indent="0" algn="ctr">
              <a:buNone/>
              <a:defRPr sz="2524"/>
            </a:lvl6pPr>
            <a:lvl7pPr marL="4326849" indent="0" algn="ctr">
              <a:buNone/>
              <a:defRPr sz="2524"/>
            </a:lvl7pPr>
            <a:lvl8pPr marL="5047991" indent="0" algn="ctr">
              <a:buNone/>
              <a:defRPr sz="2524"/>
            </a:lvl8pPr>
            <a:lvl9pPr marL="5769132" indent="0" algn="ctr">
              <a:buNone/>
              <a:defRPr sz="252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4F10-BA21-4AA5-9380-8DEF8467F148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ACCE-9EFC-428D-97F6-D2EFFE440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6735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4F10-BA21-4AA5-9380-8DEF8467F148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ACCE-9EFC-428D-97F6-D2EFFE440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803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527820" y="575917"/>
            <a:ext cx="3172138" cy="916709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11407" y="575917"/>
            <a:ext cx="9332521" cy="916709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4F10-BA21-4AA5-9380-8DEF8467F148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ACCE-9EFC-428D-97F6-D2EFFE440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2348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4F10-BA21-4AA5-9380-8DEF8467F148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ACCE-9EFC-428D-97F6-D2EFFE440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11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3745" y="2696798"/>
            <a:ext cx="12688551" cy="4499664"/>
          </a:xfrm>
        </p:spPr>
        <p:txBody>
          <a:bodyPr anchor="b"/>
          <a:lstStyle>
            <a:lvl1pPr>
              <a:defRPr sz="946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3745" y="7239030"/>
            <a:ext cx="12688551" cy="2366267"/>
          </a:xfrm>
        </p:spPr>
        <p:txBody>
          <a:bodyPr/>
          <a:lstStyle>
            <a:lvl1pPr marL="0" indent="0">
              <a:buNone/>
              <a:defRPr sz="3786">
                <a:solidFill>
                  <a:schemeClr val="tx1"/>
                </a:solidFill>
              </a:defRPr>
            </a:lvl1pPr>
            <a:lvl2pPr marL="721142" indent="0">
              <a:buNone/>
              <a:defRPr sz="3155">
                <a:solidFill>
                  <a:schemeClr val="tx1">
                    <a:tint val="75000"/>
                  </a:schemeClr>
                </a:solidFill>
              </a:defRPr>
            </a:lvl2pPr>
            <a:lvl3pPr marL="1442283" indent="0">
              <a:buNone/>
              <a:defRPr sz="2839">
                <a:solidFill>
                  <a:schemeClr val="tx1">
                    <a:tint val="75000"/>
                  </a:schemeClr>
                </a:solidFill>
              </a:defRPr>
            </a:lvl3pPr>
            <a:lvl4pPr marL="2163425" indent="0">
              <a:buNone/>
              <a:defRPr sz="2524">
                <a:solidFill>
                  <a:schemeClr val="tx1">
                    <a:tint val="75000"/>
                  </a:schemeClr>
                </a:solidFill>
              </a:defRPr>
            </a:lvl4pPr>
            <a:lvl5pPr marL="2884566" indent="0">
              <a:buNone/>
              <a:defRPr sz="2524">
                <a:solidFill>
                  <a:schemeClr val="tx1">
                    <a:tint val="75000"/>
                  </a:schemeClr>
                </a:solidFill>
              </a:defRPr>
            </a:lvl5pPr>
            <a:lvl6pPr marL="3605708" indent="0">
              <a:buNone/>
              <a:defRPr sz="2524">
                <a:solidFill>
                  <a:schemeClr val="tx1">
                    <a:tint val="75000"/>
                  </a:schemeClr>
                </a:solidFill>
              </a:defRPr>
            </a:lvl6pPr>
            <a:lvl7pPr marL="4326849" indent="0">
              <a:buNone/>
              <a:defRPr sz="2524">
                <a:solidFill>
                  <a:schemeClr val="tx1">
                    <a:tint val="75000"/>
                  </a:schemeClr>
                </a:solidFill>
              </a:defRPr>
            </a:lvl7pPr>
            <a:lvl8pPr marL="5047991" indent="0">
              <a:buNone/>
              <a:defRPr sz="2524">
                <a:solidFill>
                  <a:schemeClr val="tx1">
                    <a:tint val="75000"/>
                  </a:schemeClr>
                </a:solidFill>
              </a:defRPr>
            </a:lvl8pPr>
            <a:lvl9pPr marL="5769132" indent="0">
              <a:buNone/>
              <a:defRPr sz="252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4F10-BA21-4AA5-9380-8DEF8467F148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ACCE-9EFC-428D-97F6-D2EFFE440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8733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11406" y="2879585"/>
            <a:ext cx="6252329" cy="686343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47628" y="2879585"/>
            <a:ext cx="6252329" cy="686343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4F10-BA21-4AA5-9380-8DEF8467F148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ACCE-9EFC-428D-97F6-D2EFFE440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2901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3322" y="575920"/>
            <a:ext cx="12688551" cy="209083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13324" y="2651723"/>
            <a:ext cx="6223595" cy="1299569"/>
          </a:xfrm>
        </p:spPr>
        <p:txBody>
          <a:bodyPr anchor="b"/>
          <a:lstStyle>
            <a:lvl1pPr marL="0" indent="0">
              <a:buNone/>
              <a:defRPr sz="3786" b="1"/>
            </a:lvl1pPr>
            <a:lvl2pPr marL="721142" indent="0">
              <a:buNone/>
              <a:defRPr sz="3155" b="1"/>
            </a:lvl2pPr>
            <a:lvl3pPr marL="1442283" indent="0">
              <a:buNone/>
              <a:defRPr sz="2839" b="1"/>
            </a:lvl3pPr>
            <a:lvl4pPr marL="2163425" indent="0">
              <a:buNone/>
              <a:defRPr sz="2524" b="1"/>
            </a:lvl4pPr>
            <a:lvl5pPr marL="2884566" indent="0">
              <a:buNone/>
              <a:defRPr sz="2524" b="1"/>
            </a:lvl5pPr>
            <a:lvl6pPr marL="3605708" indent="0">
              <a:buNone/>
              <a:defRPr sz="2524" b="1"/>
            </a:lvl6pPr>
            <a:lvl7pPr marL="4326849" indent="0">
              <a:buNone/>
              <a:defRPr sz="2524" b="1"/>
            </a:lvl7pPr>
            <a:lvl8pPr marL="5047991" indent="0">
              <a:buNone/>
              <a:defRPr sz="2524" b="1"/>
            </a:lvl8pPr>
            <a:lvl9pPr marL="5769132" indent="0">
              <a:buNone/>
              <a:defRPr sz="252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13324" y="3951292"/>
            <a:ext cx="6223595" cy="58117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47629" y="2651723"/>
            <a:ext cx="6254245" cy="1299569"/>
          </a:xfrm>
        </p:spPr>
        <p:txBody>
          <a:bodyPr anchor="b"/>
          <a:lstStyle>
            <a:lvl1pPr marL="0" indent="0">
              <a:buNone/>
              <a:defRPr sz="3786" b="1"/>
            </a:lvl1pPr>
            <a:lvl2pPr marL="721142" indent="0">
              <a:buNone/>
              <a:defRPr sz="3155" b="1"/>
            </a:lvl2pPr>
            <a:lvl3pPr marL="1442283" indent="0">
              <a:buNone/>
              <a:defRPr sz="2839" b="1"/>
            </a:lvl3pPr>
            <a:lvl4pPr marL="2163425" indent="0">
              <a:buNone/>
              <a:defRPr sz="2524" b="1"/>
            </a:lvl4pPr>
            <a:lvl5pPr marL="2884566" indent="0">
              <a:buNone/>
              <a:defRPr sz="2524" b="1"/>
            </a:lvl5pPr>
            <a:lvl6pPr marL="3605708" indent="0">
              <a:buNone/>
              <a:defRPr sz="2524" b="1"/>
            </a:lvl6pPr>
            <a:lvl7pPr marL="4326849" indent="0">
              <a:buNone/>
              <a:defRPr sz="2524" b="1"/>
            </a:lvl7pPr>
            <a:lvl8pPr marL="5047991" indent="0">
              <a:buNone/>
              <a:defRPr sz="2524" b="1"/>
            </a:lvl8pPr>
            <a:lvl9pPr marL="5769132" indent="0">
              <a:buNone/>
              <a:defRPr sz="252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47629" y="3951292"/>
            <a:ext cx="6254245" cy="58117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4F10-BA21-4AA5-9380-8DEF8467F148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ACCE-9EFC-428D-97F6-D2EFFE440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352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4F10-BA21-4AA5-9380-8DEF8467F148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ACCE-9EFC-428D-97F6-D2EFFE440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7983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4F10-BA21-4AA5-9380-8DEF8467F148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ACCE-9EFC-428D-97F6-D2EFFE440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7579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3323" y="721148"/>
            <a:ext cx="4744797" cy="2524019"/>
          </a:xfrm>
        </p:spPr>
        <p:txBody>
          <a:bodyPr anchor="b"/>
          <a:lstStyle>
            <a:lvl1pPr>
              <a:defRPr sz="50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54245" y="1557482"/>
            <a:ext cx="7447628" cy="7687241"/>
          </a:xfrm>
        </p:spPr>
        <p:txBody>
          <a:bodyPr/>
          <a:lstStyle>
            <a:lvl1pPr>
              <a:defRPr sz="5047"/>
            </a:lvl1pPr>
            <a:lvl2pPr>
              <a:defRPr sz="4416"/>
            </a:lvl2pPr>
            <a:lvl3pPr>
              <a:defRPr sz="3786"/>
            </a:lvl3pPr>
            <a:lvl4pPr>
              <a:defRPr sz="3155"/>
            </a:lvl4pPr>
            <a:lvl5pPr>
              <a:defRPr sz="3155"/>
            </a:lvl5pPr>
            <a:lvl6pPr>
              <a:defRPr sz="3155"/>
            </a:lvl6pPr>
            <a:lvl7pPr>
              <a:defRPr sz="3155"/>
            </a:lvl7pPr>
            <a:lvl8pPr>
              <a:defRPr sz="3155"/>
            </a:lvl8pPr>
            <a:lvl9pPr>
              <a:defRPr sz="315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13323" y="3245168"/>
            <a:ext cx="4744797" cy="6012074"/>
          </a:xfrm>
        </p:spPr>
        <p:txBody>
          <a:bodyPr/>
          <a:lstStyle>
            <a:lvl1pPr marL="0" indent="0">
              <a:buNone/>
              <a:defRPr sz="2524"/>
            </a:lvl1pPr>
            <a:lvl2pPr marL="721142" indent="0">
              <a:buNone/>
              <a:defRPr sz="2208"/>
            </a:lvl2pPr>
            <a:lvl3pPr marL="1442283" indent="0">
              <a:buNone/>
              <a:defRPr sz="1893"/>
            </a:lvl3pPr>
            <a:lvl4pPr marL="2163425" indent="0">
              <a:buNone/>
              <a:defRPr sz="1577"/>
            </a:lvl4pPr>
            <a:lvl5pPr marL="2884566" indent="0">
              <a:buNone/>
              <a:defRPr sz="1577"/>
            </a:lvl5pPr>
            <a:lvl6pPr marL="3605708" indent="0">
              <a:buNone/>
              <a:defRPr sz="1577"/>
            </a:lvl6pPr>
            <a:lvl7pPr marL="4326849" indent="0">
              <a:buNone/>
              <a:defRPr sz="1577"/>
            </a:lvl7pPr>
            <a:lvl8pPr marL="5047991" indent="0">
              <a:buNone/>
              <a:defRPr sz="1577"/>
            </a:lvl8pPr>
            <a:lvl9pPr marL="5769132" indent="0">
              <a:buNone/>
              <a:defRPr sz="157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4F10-BA21-4AA5-9380-8DEF8467F148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ACCE-9EFC-428D-97F6-D2EFFE440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4138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3323" y="721148"/>
            <a:ext cx="4744797" cy="2524019"/>
          </a:xfrm>
        </p:spPr>
        <p:txBody>
          <a:bodyPr anchor="b"/>
          <a:lstStyle>
            <a:lvl1pPr>
              <a:defRPr sz="50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54245" y="1557482"/>
            <a:ext cx="7447628" cy="7687241"/>
          </a:xfrm>
        </p:spPr>
        <p:txBody>
          <a:bodyPr anchor="t"/>
          <a:lstStyle>
            <a:lvl1pPr marL="0" indent="0">
              <a:buNone/>
              <a:defRPr sz="5047"/>
            </a:lvl1pPr>
            <a:lvl2pPr marL="721142" indent="0">
              <a:buNone/>
              <a:defRPr sz="4416"/>
            </a:lvl2pPr>
            <a:lvl3pPr marL="1442283" indent="0">
              <a:buNone/>
              <a:defRPr sz="3786"/>
            </a:lvl3pPr>
            <a:lvl4pPr marL="2163425" indent="0">
              <a:buNone/>
              <a:defRPr sz="3155"/>
            </a:lvl4pPr>
            <a:lvl5pPr marL="2884566" indent="0">
              <a:buNone/>
              <a:defRPr sz="3155"/>
            </a:lvl5pPr>
            <a:lvl6pPr marL="3605708" indent="0">
              <a:buNone/>
              <a:defRPr sz="3155"/>
            </a:lvl6pPr>
            <a:lvl7pPr marL="4326849" indent="0">
              <a:buNone/>
              <a:defRPr sz="3155"/>
            </a:lvl7pPr>
            <a:lvl8pPr marL="5047991" indent="0">
              <a:buNone/>
              <a:defRPr sz="3155"/>
            </a:lvl8pPr>
            <a:lvl9pPr marL="5769132" indent="0">
              <a:buNone/>
              <a:defRPr sz="315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13323" y="3245168"/>
            <a:ext cx="4744797" cy="6012074"/>
          </a:xfrm>
        </p:spPr>
        <p:txBody>
          <a:bodyPr/>
          <a:lstStyle>
            <a:lvl1pPr marL="0" indent="0">
              <a:buNone/>
              <a:defRPr sz="2524"/>
            </a:lvl1pPr>
            <a:lvl2pPr marL="721142" indent="0">
              <a:buNone/>
              <a:defRPr sz="2208"/>
            </a:lvl2pPr>
            <a:lvl3pPr marL="1442283" indent="0">
              <a:buNone/>
              <a:defRPr sz="1893"/>
            </a:lvl3pPr>
            <a:lvl4pPr marL="2163425" indent="0">
              <a:buNone/>
              <a:defRPr sz="1577"/>
            </a:lvl4pPr>
            <a:lvl5pPr marL="2884566" indent="0">
              <a:buNone/>
              <a:defRPr sz="1577"/>
            </a:lvl5pPr>
            <a:lvl6pPr marL="3605708" indent="0">
              <a:buNone/>
              <a:defRPr sz="1577"/>
            </a:lvl6pPr>
            <a:lvl7pPr marL="4326849" indent="0">
              <a:buNone/>
              <a:defRPr sz="1577"/>
            </a:lvl7pPr>
            <a:lvl8pPr marL="5047991" indent="0">
              <a:buNone/>
              <a:defRPr sz="1577"/>
            </a:lvl8pPr>
            <a:lvl9pPr marL="5769132" indent="0">
              <a:buNone/>
              <a:defRPr sz="157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4F10-BA21-4AA5-9380-8DEF8467F148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CACCE-9EFC-428D-97F6-D2EFFE440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2472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11406" y="575920"/>
            <a:ext cx="12688551" cy="2090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11406" y="2879585"/>
            <a:ext cx="12688551" cy="68634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11406" y="10025967"/>
            <a:ext cx="3310057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6D4F10-BA21-4AA5-9380-8DEF8467F148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73139" y="10025967"/>
            <a:ext cx="4965085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89900" y="10025967"/>
            <a:ext cx="3310057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8CACCE-9EFC-428D-97F6-D2EFFE440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619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442283" rtl="0" eaLnBrk="1" latinLnBrk="0" hangingPunct="1">
        <a:lnSpc>
          <a:spcPct val="90000"/>
        </a:lnSpc>
        <a:spcBef>
          <a:spcPct val="0"/>
        </a:spcBef>
        <a:buNone/>
        <a:defRPr kumimoji="1" sz="69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0571" indent="-360571" algn="l" defTabSz="1442283" rtl="0" eaLnBrk="1" latinLnBrk="0" hangingPunct="1">
        <a:lnSpc>
          <a:spcPct val="90000"/>
        </a:lnSpc>
        <a:spcBef>
          <a:spcPts val="1577"/>
        </a:spcBef>
        <a:buFont typeface="Arial" panose="020B0604020202020204" pitchFamily="34" charset="0"/>
        <a:buChar char="•"/>
        <a:defRPr kumimoji="1" sz="4416" kern="1200">
          <a:solidFill>
            <a:schemeClr val="tx1"/>
          </a:solidFill>
          <a:latin typeface="+mn-lt"/>
          <a:ea typeface="+mn-ea"/>
          <a:cs typeface="+mn-cs"/>
        </a:defRPr>
      </a:lvl1pPr>
      <a:lvl2pPr marL="1081712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kumimoji="1" sz="3786" kern="1200">
          <a:solidFill>
            <a:schemeClr val="tx1"/>
          </a:solidFill>
          <a:latin typeface="+mn-lt"/>
          <a:ea typeface="+mn-ea"/>
          <a:cs typeface="+mn-cs"/>
        </a:defRPr>
      </a:lvl2pPr>
      <a:lvl3pPr marL="1802854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kumimoji="1" sz="3155" kern="1200">
          <a:solidFill>
            <a:schemeClr val="tx1"/>
          </a:solidFill>
          <a:latin typeface="+mn-lt"/>
          <a:ea typeface="+mn-ea"/>
          <a:cs typeface="+mn-cs"/>
        </a:defRPr>
      </a:lvl3pPr>
      <a:lvl4pPr marL="2523995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4pPr>
      <a:lvl5pPr marL="3245137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5pPr>
      <a:lvl6pPr marL="3966279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6pPr>
      <a:lvl7pPr marL="4687420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7pPr>
      <a:lvl8pPr marL="5408562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8pPr>
      <a:lvl9pPr marL="6129703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42283" rtl="0" eaLnBrk="1" latinLnBrk="0" hangingPunct="1"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1pPr>
      <a:lvl2pPr marL="721142" algn="l" defTabSz="1442283" rtl="0" eaLnBrk="1" latinLnBrk="0" hangingPunct="1"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2pPr>
      <a:lvl3pPr marL="1442283" algn="l" defTabSz="1442283" rtl="0" eaLnBrk="1" latinLnBrk="0" hangingPunct="1"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3pPr>
      <a:lvl4pPr marL="2163425" algn="l" defTabSz="1442283" rtl="0" eaLnBrk="1" latinLnBrk="0" hangingPunct="1"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4pPr>
      <a:lvl5pPr marL="2884566" algn="l" defTabSz="1442283" rtl="0" eaLnBrk="1" latinLnBrk="0" hangingPunct="1"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5pPr>
      <a:lvl6pPr marL="3605708" algn="l" defTabSz="1442283" rtl="0" eaLnBrk="1" latinLnBrk="0" hangingPunct="1"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6pPr>
      <a:lvl7pPr marL="4326849" algn="l" defTabSz="1442283" rtl="0" eaLnBrk="1" latinLnBrk="0" hangingPunct="1"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7pPr>
      <a:lvl8pPr marL="5047991" algn="l" defTabSz="1442283" rtl="0" eaLnBrk="1" latinLnBrk="0" hangingPunct="1"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8pPr>
      <a:lvl9pPr marL="5769132" algn="l" defTabSz="1442283" rtl="0" eaLnBrk="1" latinLnBrk="0" hangingPunct="1">
        <a:defRPr kumimoji="1" sz="283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78CB20AB-21DA-27CF-7B2B-3114E72ED2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0596428"/>
              </p:ext>
            </p:extLst>
          </p:nvPr>
        </p:nvGraphicFramePr>
        <p:xfrm>
          <a:off x="8022346" y="3804808"/>
          <a:ext cx="5972472" cy="1939245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998610">
                  <a:extLst>
                    <a:ext uri="{9D8B030D-6E8A-4147-A177-3AD203B41FA5}">
                      <a16:colId xmlns:a16="http://schemas.microsoft.com/office/drawing/2014/main" val="2794200430"/>
                    </a:ext>
                  </a:extLst>
                </a:gridCol>
                <a:gridCol w="1167866">
                  <a:extLst>
                    <a:ext uri="{9D8B030D-6E8A-4147-A177-3AD203B41FA5}">
                      <a16:colId xmlns:a16="http://schemas.microsoft.com/office/drawing/2014/main" val="3367895100"/>
                    </a:ext>
                  </a:extLst>
                </a:gridCol>
                <a:gridCol w="1495933">
                  <a:extLst>
                    <a:ext uri="{9D8B030D-6E8A-4147-A177-3AD203B41FA5}">
                      <a16:colId xmlns:a16="http://schemas.microsoft.com/office/drawing/2014/main" val="2095806312"/>
                    </a:ext>
                  </a:extLst>
                </a:gridCol>
                <a:gridCol w="1459832">
                  <a:extLst>
                    <a:ext uri="{9D8B030D-6E8A-4147-A177-3AD203B41FA5}">
                      <a16:colId xmlns:a16="http://schemas.microsoft.com/office/drawing/2014/main" val="4240534624"/>
                    </a:ext>
                  </a:extLst>
                </a:gridCol>
                <a:gridCol w="850231">
                  <a:extLst>
                    <a:ext uri="{9D8B030D-6E8A-4147-A177-3AD203B41FA5}">
                      <a16:colId xmlns:a16="http://schemas.microsoft.com/office/drawing/2014/main" val="2210554656"/>
                    </a:ext>
                  </a:extLst>
                </a:gridCol>
              </a:tblGrid>
              <a:tr h="646415"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+mn-lt"/>
                        </a:rPr>
                        <a:t>non-treatment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Chemotherapy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Radiation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+mn-lt"/>
                        </a:rPr>
                        <a:t>CRT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284410332"/>
                  </a:ext>
                </a:extLst>
              </a:tr>
              <a:tr h="64641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+mn-lt"/>
                        </a:rPr>
                        <a:t>high volum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215 </a:t>
                      </a:r>
                    </a:p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(44%)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74</a:t>
                      </a:r>
                    </a:p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 (15%)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100</a:t>
                      </a:r>
                    </a:p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 (20%)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104</a:t>
                      </a:r>
                    </a:p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(21%)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294099074"/>
                  </a:ext>
                </a:extLst>
              </a:tr>
              <a:tr h="64641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+mn-lt"/>
                        </a:rPr>
                        <a:t>non-high volum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413 </a:t>
                      </a:r>
                    </a:p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(37%)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266 </a:t>
                      </a:r>
                    </a:p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(24%)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212 </a:t>
                      </a:r>
                    </a:p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(19%)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229 </a:t>
                      </a:r>
                    </a:p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+mn-lt"/>
                        </a:rPr>
                        <a:t>(20%)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521499781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6E829D7-3DC1-805C-2771-E8D502BCD688}"/>
              </a:ext>
            </a:extLst>
          </p:cNvPr>
          <p:cNvSpPr txBox="1"/>
          <p:nvPr/>
        </p:nvSpPr>
        <p:spPr>
          <a:xfrm>
            <a:off x="149131" y="99586"/>
            <a:ext cx="10422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/>
              <a:t>Fig S1</a:t>
            </a:r>
            <a:endParaRPr kumimoji="1" lang="ja-JP" altLang="en-US" sz="2800" b="1" dirty="0"/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8DBD0B79-0206-5A36-6959-4ECE2D0876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4456078"/>
              </p:ext>
            </p:extLst>
          </p:nvPr>
        </p:nvGraphicFramePr>
        <p:xfrm>
          <a:off x="1301079" y="2419371"/>
          <a:ext cx="6390210" cy="41172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2FE5601-1530-7431-2430-EF471907A9BB}"/>
              </a:ext>
            </a:extLst>
          </p:cNvPr>
          <p:cNvSpPr txBox="1"/>
          <p:nvPr/>
        </p:nvSpPr>
        <p:spPr>
          <a:xfrm>
            <a:off x="1914226" y="8024477"/>
            <a:ext cx="11797309" cy="12926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1  Treatment selection according to types of institutions</a:t>
            </a:r>
            <a:endParaRPr lang="ja-JP" altLang="ja-JP" sz="2400" b="1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  <a:p>
            <a:pPr algn="l"/>
            <a:r>
              <a:rPr lang="en-US" altLang="ja-JP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eatment selections were divided into “non-treatment,” “chemotherapy,” “radiation,” and “chemoradiotherapy (CRT).” Treatment selection was compared between the high volume and non-high volume centers.  </a:t>
            </a:r>
            <a:endParaRPr lang="ja-JP" altLang="ja-JP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  <a:p>
            <a:pPr algn="l"/>
            <a:r>
              <a:rPr lang="en-US" altLang="ja-JP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RT, chemoradiotherapy</a:t>
            </a:r>
            <a:endParaRPr lang="ja-JP" altLang="ja-JP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51405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114AADC-165B-34A9-B7DB-6E5BCA1AED1C}"/>
              </a:ext>
            </a:extLst>
          </p:cNvPr>
          <p:cNvSpPr txBox="1"/>
          <p:nvPr/>
        </p:nvSpPr>
        <p:spPr>
          <a:xfrm>
            <a:off x="149131" y="99586"/>
            <a:ext cx="10422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/>
              <a:t>Fig S2</a:t>
            </a:r>
            <a:endParaRPr kumimoji="1" lang="ja-JP" altLang="en-US" sz="2800" b="1" dirty="0"/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DD7E91A4-85E2-7D4E-52C1-D40EC63046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7384367"/>
              </p:ext>
            </p:extLst>
          </p:nvPr>
        </p:nvGraphicFramePr>
        <p:xfrm>
          <a:off x="2636974" y="1200830"/>
          <a:ext cx="8758988" cy="66093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AC62155-7B6F-5E56-35BD-D51FF3BE5D73}"/>
              </a:ext>
            </a:extLst>
          </p:cNvPr>
          <p:cNvSpPr txBox="1"/>
          <p:nvPr/>
        </p:nvSpPr>
        <p:spPr>
          <a:xfrm>
            <a:off x="9189056" y="7938515"/>
            <a:ext cx="2478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RT, chemoradiotherapy</a:t>
            </a:r>
            <a:endParaRPr kumimoji="1"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D737940-6622-51B4-9A76-0639D259CB75}"/>
              </a:ext>
            </a:extLst>
          </p:cNvPr>
          <p:cNvSpPr txBox="1"/>
          <p:nvPr/>
        </p:nvSpPr>
        <p:spPr>
          <a:xfrm>
            <a:off x="1554035" y="8793084"/>
            <a:ext cx="11852250" cy="12926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2  Treatment selection by institutions among high-volume centers</a:t>
            </a:r>
            <a:endParaRPr lang="ja-JP" altLang="ja-JP" sz="2400" b="1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  <a:p>
            <a:pPr algn="l"/>
            <a:r>
              <a:rPr lang="en-US" altLang="ja-JP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eatment selections were divided into “non-treatment,” “chemotherapy,” “radiation,” and “chemoradiotherapy (CRT).” Treatment selection was compared among high-volume centers.</a:t>
            </a:r>
            <a:endParaRPr lang="ja-JP" altLang="ja-JP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  <a:p>
            <a:pPr algn="l"/>
            <a:r>
              <a:rPr lang="en-US" altLang="ja-JP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RT, chemoradiotherapy</a:t>
            </a:r>
            <a:endParaRPr lang="ja-JP" altLang="ja-JP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65098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7DF88A3-BF2E-CD89-9B50-8F1E28C5D967}"/>
              </a:ext>
            </a:extLst>
          </p:cNvPr>
          <p:cNvSpPr txBox="1"/>
          <p:nvPr/>
        </p:nvSpPr>
        <p:spPr>
          <a:xfrm>
            <a:off x="149131" y="99586"/>
            <a:ext cx="10422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/>
              <a:t>Fig S3</a:t>
            </a:r>
            <a:endParaRPr kumimoji="1" lang="ja-JP" altLang="en-US" sz="2800" b="1" dirty="0"/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DE92BC18-C821-ABBD-136C-2B4161DAA7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9896276"/>
              </p:ext>
            </p:extLst>
          </p:nvPr>
        </p:nvGraphicFramePr>
        <p:xfrm>
          <a:off x="4235116" y="2053390"/>
          <a:ext cx="5984081" cy="47749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CB7DBD8-DA60-9B6D-BBDC-4676226BC04F}"/>
              </a:ext>
            </a:extLst>
          </p:cNvPr>
          <p:cNvSpPr txBox="1"/>
          <p:nvPr/>
        </p:nvSpPr>
        <p:spPr>
          <a:xfrm>
            <a:off x="8477136" y="6978316"/>
            <a:ext cx="2478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RT, chemoradiotherapy</a:t>
            </a:r>
            <a:endParaRPr kumimoji="1" lang="ja-JP" altLang="en-US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CC8571B-2996-74CE-BFD3-291FD424303B}"/>
              </a:ext>
            </a:extLst>
          </p:cNvPr>
          <p:cNvSpPr txBox="1"/>
          <p:nvPr/>
        </p:nvSpPr>
        <p:spPr>
          <a:xfrm>
            <a:off x="1934329" y="8319445"/>
            <a:ext cx="11411564" cy="12926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3  Treatment selection according to the number of recurrent risk factors</a:t>
            </a:r>
            <a:endParaRPr lang="ja-JP" altLang="ja-JP" sz="2400" b="1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  <a:p>
            <a:pPr algn="l"/>
            <a:r>
              <a:rPr lang="en-US" altLang="ja-JP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eatment selections were divided into “non-treatment,” “chemotherapy,” “radiation,” and “chemoradiotherapy (CRT).” Treatment selection was compared based on the number of recurrent risk factors.</a:t>
            </a:r>
            <a:endParaRPr lang="ja-JP" altLang="ja-JP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  <a:p>
            <a:pPr algn="l"/>
            <a:r>
              <a:rPr lang="en-US" altLang="ja-JP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RT, chemoradiotherapy</a:t>
            </a:r>
            <a:endParaRPr lang="ja-JP" altLang="ja-JP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03304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AF3B6AB-97CA-6345-028A-A5B525D824B3}"/>
              </a:ext>
            </a:extLst>
          </p:cNvPr>
          <p:cNvSpPr txBox="1"/>
          <p:nvPr/>
        </p:nvSpPr>
        <p:spPr>
          <a:xfrm>
            <a:off x="149131" y="99586"/>
            <a:ext cx="10422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/>
              <a:t>Fig S4</a:t>
            </a:r>
            <a:endParaRPr kumimoji="1" lang="ja-JP" altLang="en-US" sz="2800" b="1" dirty="0"/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951AC297-1DC1-9CAE-7C32-A7944FC6E1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5091666"/>
              </p:ext>
            </p:extLst>
          </p:nvPr>
        </p:nvGraphicFramePr>
        <p:xfrm>
          <a:off x="1103548" y="2974642"/>
          <a:ext cx="5954796" cy="36507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13F6CED6-35B5-4806-8FC3-537208643E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4650304"/>
              </p:ext>
            </p:extLst>
          </p:nvPr>
        </p:nvGraphicFramePr>
        <p:xfrm>
          <a:off x="7860631" y="2974642"/>
          <a:ext cx="5309935" cy="35132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9D14BFE-1C21-44AF-846F-FB6A7D3B4876}"/>
              </a:ext>
            </a:extLst>
          </p:cNvPr>
          <p:cNvSpPr txBox="1"/>
          <p:nvPr/>
        </p:nvSpPr>
        <p:spPr>
          <a:xfrm>
            <a:off x="978568" y="2374232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A</a:t>
            </a:r>
            <a:endParaRPr kumimoji="1" lang="ja-JP" altLang="en-US" sz="2400" b="1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A0AD2BB-00BD-7B35-C41B-413BE76DE0C7}"/>
              </a:ext>
            </a:extLst>
          </p:cNvPr>
          <p:cNvSpPr txBox="1"/>
          <p:nvPr/>
        </p:nvSpPr>
        <p:spPr>
          <a:xfrm>
            <a:off x="7675324" y="2374231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B</a:t>
            </a:r>
            <a:endParaRPr kumimoji="1" lang="ja-JP" altLang="en-US" sz="2400" b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6BB1168-3C10-4A66-8F0B-2C478597A9CC}"/>
              </a:ext>
            </a:extLst>
          </p:cNvPr>
          <p:cNvSpPr txBox="1"/>
          <p:nvPr/>
        </p:nvSpPr>
        <p:spPr>
          <a:xfrm>
            <a:off x="1717892" y="8147551"/>
            <a:ext cx="1164414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4  Number of recurrent risk factors in (A) non-treatment and (B) treatment groups </a:t>
            </a:r>
          </a:p>
          <a:p>
            <a:pPr algn="l"/>
            <a:r>
              <a:rPr lang="en-US" altLang="ja-JP" sz="2400" b="1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           </a:t>
            </a:r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fter propensity-matching</a:t>
            </a:r>
            <a:endParaRPr lang="ja-JP" altLang="ja-JP" sz="2400" b="1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86465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AF3B6AB-97CA-6345-028A-A5B525D824B3}"/>
              </a:ext>
            </a:extLst>
          </p:cNvPr>
          <p:cNvSpPr txBox="1"/>
          <p:nvPr/>
        </p:nvSpPr>
        <p:spPr>
          <a:xfrm>
            <a:off x="149131" y="99586"/>
            <a:ext cx="10422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/>
              <a:t>Fig S5</a:t>
            </a:r>
            <a:endParaRPr kumimoji="1" lang="ja-JP" altLang="en-US" sz="2800" b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9D14BFE-1C21-44AF-846F-FB6A7D3B4876}"/>
              </a:ext>
            </a:extLst>
          </p:cNvPr>
          <p:cNvSpPr txBox="1"/>
          <p:nvPr/>
        </p:nvSpPr>
        <p:spPr>
          <a:xfrm>
            <a:off x="978568" y="2374232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A</a:t>
            </a:r>
            <a:endParaRPr kumimoji="1" lang="ja-JP" altLang="en-US" sz="2400" b="1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A0AD2BB-00BD-7B35-C41B-413BE76DE0C7}"/>
              </a:ext>
            </a:extLst>
          </p:cNvPr>
          <p:cNvSpPr txBox="1"/>
          <p:nvPr/>
        </p:nvSpPr>
        <p:spPr>
          <a:xfrm>
            <a:off x="7675324" y="2374231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B</a:t>
            </a:r>
            <a:endParaRPr kumimoji="1" lang="ja-JP" altLang="en-US" sz="2400" b="1" dirty="0"/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4FED5D01-6EE1-4B5E-9F04-839AB71E34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6874697"/>
              </p:ext>
            </p:extLst>
          </p:nvPr>
        </p:nvGraphicFramePr>
        <p:xfrm>
          <a:off x="1163875" y="2974642"/>
          <a:ext cx="5954045" cy="35132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C7BCF770-0CDB-4276-8CC9-4AB20AFF7B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0686921"/>
              </p:ext>
            </p:extLst>
          </p:nvPr>
        </p:nvGraphicFramePr>
        <p:xfrm>
          <a:off x="7763014" y="2974642"/>
          <a:ext cx="5784474" cy="35132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B76DC0D-E86A-FFDB-2E4B-73742385C510}"/>
              </a:ext>
            </a:extLst>
          </p:cNvPr>
          <p:cNvSpPr txBox="1"/>
          <p:nvPr/>
        </p:nvSpPr>
        <p:spPr>
          <a:xfrm>
            <a:off x="2123768" y="8027495"/>
            <a:ext cx="1111095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5  Number of recurrent risk factors in (A) radiation and</a:t>
            </a:r>
            <a:r>
              <a:rPr lang="en-US" altLang="ja-JP" sz="2400" b="1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B) chemotherapy groups </a:t>
            </a:r>
          </a:p>
          <a:p>
            <a:pPr algn="l"/>
            <a:r>
              <a:rPr lang="en-US" altLang="ja-JP" sz="2400" b="1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           </a:t>
            </a:r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fter propensity-matching</a:t>
            </a:r>
            <a:endParaRPr lang="ja-JP" altLang="ja-JP" sz="2400" b="1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04909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5DAA5656-BF87-2B8E-7782-9FBD2EB8E083}"/>
              </a:ext>
            </a:extLst>
          </p:cNvPr>
          <p:cNvSpPr/>
          <p:nvPr/>
        </p:nvSpPr>
        <p:spPr>
          <a:xfrm>
            <a:off x="2128702" y="2458879"/>
            <a:ext cx="2049790" cy="884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Chemotherapy</a:t>
            </a:r>
          </a:p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n = 285</a:t>
            </a: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D159727C-55E3-7949-44BD-6AAC95ADC055}"/>
              </a:ext>
            </a:extLst>
          </p:cNvPr>
          <p:cNvSpPr/>
          <p:nvPr/>
        </p:nvSpPr>
        <p:spPr>
          <a:xfrm>
            <a:off x="4762268" y="2458879"/>
            <a:ext cx="1996064" cy="884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Radiation</a:t>
            </a:r>
          </a:p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n = 583</a:t>
            </a: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7D7CB3B7-08DE-A365-369E-45C09C0AFF0F}"/>
              </a:ext>
            </a:extLst>
          </p:cNvPr>
          <p:cNvSpPr/>
          <p:nvPr/>
        </p:nvSpPr>
        <p:spPr>
          <a:xfrm>
            <a:off x="2649518" y="3764851"/>
            <a:ext cx="3615033" cy="5343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b="1" dirty="0">
                <a:solidFill>
                  <a:srgbClr val="7030A0"/>
                </a:solidFill>
              </a:rPr>
              <a:t>Propensity score matching</a:t>
            </a:r>
            <a:endParaRPr kumimoji="1" lang="ja-JP" altLang="en-US" sz="2400" b="1" dirty="0">
              <a:solidFill>
                <a:srgbClr val="7030A0"/>
              </a:solidFill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740F1CEA-1F4B-416E-0A00-FEDAE09686AD}"/>
              </a:ext>
            </a:extLst>
          </p:cNvPr>
          <p:cNvGrpSpPr/>
          <p:nvPr/>
        </p:nvGrpSpPr>
        <p:grpSpPr>
          <a:xfrm flipV="1">
            <a:off x="3011291" y="3340649"/>
            <a:ext cx="2800952" cy="407840"/>
            <a:chOff x="8999621" y="5631544"/>
            <a:chExt cx="2438400" cy="1108992"/>
          </a:xfrm>
        </p:grpSpPr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A4054114-69B9-3114-E0C0-A84FC530783B}"/>
                </a:ext>
              </a:extLst>
            </p:cNvPr>
            <p:cNvCxnSpPr/>
            <p:nvPr/>
          </p:nvCxnSpPr>
          <p:spPr>
            <a:xfrm>
              <a:off x="8999621" y="6192253"/>
              <a:ext cx="24384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直線矢印コネクタ 6">
              <a:extLst>
                <a:ext uri="{FF2B5EF4-FFF2-40B4-BE49-F238E27FC236}">
                  <a16:creationId xmlns:a16="http://schemas.microsoft.com/office/drawing/2014/main" id="{826FFF4B-1A3C-6227-898F-D9549E5A2C93}"/>
                </a:ext>
              </a:extLst>
            </p:cNvPr>
            <p:cNvCxnSpPr/>
            <p:nvPr/>
          </p:nvCxnSpPr>
          <p:spPr>
            <a:xfrm>
              <a:off x="8999621" y="6192253"/>
              <a:ext cx="0" cy="548283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直線矢印コネクタ 7">
              <a:extLst>
                <a:ext uri="{FF2B5EF4-FFF2-40B4-BE49-F238E27FC236}">
                  <a16:creationId xmlns:a16="http://schemas.microsoft.com/office/drawing/2014/main" id="{F48C4CE2-90BB-B4EB-B812-DB43FCB8BF04}"/>
                </a:ext>
              </a:extLst>
            </p:cNvPr>
            <p:cNvCxnSpPr/>
            <p:nvPr/>
          </p:nvCxnSpPr>
          <p:spPr>
            <a:xfrm>
              <a:off x="11438021" y="6192253"/>
              <a:ext cx="0" cy="548283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08D71FCB-EFAF-056D-B702-C788814A26BA}"/>
                </a:ext>
              </a:extLst>
            </p:cNvPr>
            <p:cNvCxnSpPr/>
            <p:nvPr/>
          </p:nvCxnSpPr>
          <p:spPr>
            <a:xfrm flipV="1">
              <a:off x="10218051" y="5631544"/>
              <a:ext cx="0" cy="560708"/>
            </a:xfrm>
            <a:prstGeom prst="line">
              <a:avLst/>
            </a:prstGeom>
            <a:ln>
              <a:headEnd type="non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2B3B4614-D400-F87E-D71F-95E6BFC73478}"/>
              </a:ext>
            </a:extLst>
          </p:cNvPr>
          <p:cNvSpPr/>
          <p:nvPr/>
        </p:nvSpPr>
        <p:spPr>
          <a:xfrm>
            <a:off x="2062660" y="4819565"/>
            <a:ext cx="2163958" cy="8848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Chemotherapy</a:t>
            </a:r>
          </a:p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n = 264</a:t>
            </a: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41E3CCCA-B167-D100-67A8-B27FCBF2CCFB}"/>
              </a:ext>
            </a:extLst>
          </p:cNvPr>
          <p:cNvSpPr/>
          <p:nvPr/>
        </p:nvSpPr>
        <p:spPr>
          <a:xfrm>
            <a:off x="4797730" y="4823391"/>
            <a:ext cx="1996064" cy="8810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Radiation</a:t>
            </a:r>
          </a:p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n = 264</a:t>
            </a: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E5219AC7-BE84-59BD-D418-A611E36D91A6}"/>
              </a:ext>
            </a:extLst>
          </p:cNvPr>
          <p:cNvGrpSpPr/>
          <p:nvPr/>
        </p:nvGrpSpPr>
        <p:grpSpPr>
          <a:xfrm flipV="1">
            <a:off x="3040605" y="5716470"/>
            <a:ext cx="2800952" cy="407840"/>
            <a:chOff x="8999621" y="5631544"/>
            <a:chExt cx="2438400" cy="1108992"/>
          </a:xfrm>
        </p:grpSpPr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08EF3FD5-03D9-BD0C-1483-293FB66C8E7B}"/>
                </a:ext>
              </a:extLst>
            </p:cNvPr>
            <p:cNvCxnSpPr/>
            <p:nvPr/>
          </p:nvCxnSpPr>
          <p:spPr>
            <a:xfrm>
              <a:off x="8999621" y="6192253"/>
              <a:ext cx="24384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直線矢印コネクタ 13">
              <a:extLst>
                <a:ext uri="{FF2B5EF4-FFF2-40B4-BE49-F238E27FC236}">
                  <a16:creationId xmlns:a16="http://schemas.microsoft.com/office/drawing/2014/main" id="{6AA985F0-A9EE-F37D-2C84-0F48BBF92FC3}"/>
                </a:ext>
              </a:extLst>
            </p:cNvPr>
            <p:cNvCxnSpPr/>
            <p:nvPr/>
          </p:nvCxnSpPr>
          <p:spPr>
            <a:xfrm>
              <a:off x="8999621" y="6192253"/>
              <a:ext cx="0" cy="548283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直線矢印コネクタ 14">
              <a:extLst>
                <a:ext uri="{FF2B5EF4-FFF2-40B4-BE49-F238E27FC236}">
                  <a16:creationId xmlns:a16="http://schemas.microsoft.com/office/drawing/2014/main" id="{9DD6459F-723B-CE0D-3307-C86DDE5553ED}"/>
                </a:ext>
              </a:extLst>
            </p:cNvPr>
            <p:cNvCxnSpPr/>
            <p:nvPr/>
          </p:nvCxnSpPr>
          <p:spPr>
            <a:xfrm>
              <a:off x="11438021" y="6192253"/>
              <a:ext cx="0" cy="548283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F90334EF-2C80-D9CF-8A7A-957EA3D9369B}"/>
                </a:ext>
              </a:extLst>
            </p:cNvPr>
            <p:cNvCxnSpPr/>
            <p:nvPr/>
          </p:nvCxnSpPr>
          <p:spPr>
            <a:xfrm flipV="1">
              <a:off x="10218051" y="5631544"/>
              <a:ext cx="0" cy="560708"/>
            </a:xfrm>
            <a:prstGeom prst="line">
              <a:avLst/>
            </a:prstGeom>
            <a:ln>
              <a:headEnd type="non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34223F2E-C641-51AA-0BC2-A66A5C55989B}"/>
              </a:ext>
            </a:extLst>
          </p:cNvPr>
          <p:cNvGrpSpPr/>
          <p:nvPr/>
        </p:nvGrpSpPr>
        <p:grpSpPr>
          <a:xfrm>
            <a:off x="3040605" y="4294214"/>
            <a:ext cx="2783198" cy="534520"/>
            <a:chOff x="8999621" y="5854912"/>
            <a:chExt cx="2438400" cy="885624"/>
          </a:xfrm>
        </p:grpSpPr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E18ED638-5624-FE33-A205-6472056854F3}"/>
                </a:ext>
              </a:extLst>
            </p:cNvPr>
            <p:cNvCxnSpPr/>
            <p:nvPr/>
          </p:nvCxnSpPr>
          <p:spPr>
            <a:xfrm>
              <a:off x="8999621" y="6192253"/>
              <a:ext cx="24384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直線矢印コネクタ 18">
              <a:extLst>
                <a:ext uri="{FF2B5EF4-FFF2-40B4-BE49-F238E27FC236}">
                  <a16:creationId xmlns:a16="http://schemas.microsoft.com/office/drawing/2014/main" id="{916F468B-0E7E-F4D6-5F10-4BE06BC53941}"/>
                </a:ext>
              </a:extLst>
            </p:cNvPr>
            <p:cNvCxnSpPr/>
            <p:nvPr/>
          </p:nvCxnSpPr>
          <p:spPr>
            <a:xfrm>
              <a:off x="8999621" y="6192253"/>
              <a:ext cx="0" cy="54828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直線矢印コネクタ 19">
              <a:extLst>
                <a:ext uri="{FF2B5EF4-FFF2-40B4-BE49-F238E27FC236}">
                  <a16:creationId xmlns:a16="http://schemas.microsoft.com/office/drawing/2014/main" id="{6978333E-9727-B056-5ED2-C6216C905023}"/>
                </a:ext>
              </a:extLst>
            </p:cNvPr>
            <p:cNvCxnSpPr/>
            <p:nvPr/>
          </p:nvCxnSpPr>
          <p:spPr>
            <a:xfrm>
              <a:off x="11438021" y="6192253"/>
              <a:ext cx="0" cy="54828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3D190936-683A-2C41-0FC5-4AAEB420E4BF}"/>
                </a:ext>
              </a:extLst>
            </p:cNvPr>
            <p:cNvCxnSpPr/>
            <p:nvPr/>
          </p:nvCxnSpPr>
          <p:spPr>
            <a:xfrm flipV="1">
              <a:off x="10220575" y="5854912"/>
              <a:ext cx="0" cy="354878"/>
            </a:xfrm>
            <a:prstGeom prst="line">
              <a:avLst/>
            </a:prstGeom>
            <a:ln>
              <a:head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69CDB5BA-574D-6381-ACD7-B33F36524D35}"/>
              </a:ext>
            </a:extLst>
          </p:cNvPr>
          <p:cNvSpPr/>
          <p:nvPr/>
        </p:nvSpPr>
        <p:spPr>
          <a:xfrm>
            <a:off x="2872080" y="6119741"/>
            <a:ext cx="3194065" cy="5561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OS/PFS analysis</a:t>
            </a:r>
            <a:endParaRPr kumimoji="1" lang="ja-JP" altLang="en-US" sz="2400" dirty="0">
              <a:solidFill>
                <a:schemeClr val="tx1"/>
              </a:solidFill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ECA15726-899B-6BF3-B071-5EA332E8E408}"/>
              </a:ext>
            </a:extLst>
          </p:cNvPr>
          <p:cNvSpPr/>
          <p:nvPr/>
        </p:nvSpPr>
        <p:spPr>
          <a:xfrm>
            <a:off x="8730767" y="2458879"/>
            <a:ext cx="2049787" cy="884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Chemotherapy</a:t>
            </a:r>
          </a:p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n = 55</a:t>
            </a: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BAEF40F6-AE2C-218B-2B96-48144FFD84D3}"/>
              </a:ext>
            </a:extLst>
          </p:cNvPr>
          <p:cNvSpPr/>
          <p:nvPr/>
        </p:nvSpPr>
        <p:spPr>
          <a:xfrm>
            <a:off x="11500662" y="2458879"/>
            <a:ext cx="2049786" cy="884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Radiation</a:t>
            </a:r>
          </a:p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n = 71</a:t>
            </a: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9A2F314C-1A81-ED8B-EA67-53863812EA81}"/>
              </a:ext>
            </a:extLst>
          </p:cNvPr>
          <p:cNvSpPr/>
          <p:nvPr/>
        </p:nvSpPr>
        <p:spPr>
          <a:xfrm>
            <a:off x="9387912" y="3764851"/>
            <a:ext cx="3615033" cy="5343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b="1" dirty="0">
                <a:solidFill>
                  <a:srgbClr val="7030A0"/>
                </a:solidFill>
              </a:rPr>
              <a:t>Propensity score matching</a:t>
            </a:r>
            <a:endParaRPr kumimoji="1" lang="ja-JP" altLang="en-US" sz="2400" b="1" dirty="0">
              <a:solidFill>
                <a:srgbClr val="7030A0"/>
              </a:solidFill>
            </a:endParaRPr>
          </a:p>
        </p:txBody>
      </p: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903DDE07-8528-A70A-BF9A-FA22D0C2844A}"/>
              </a:ext>
            </a:extLst>
          </p:cNvPr>
          <p:cNvGrpSpPr/>
          <p:nvPr/>
        </p:nvGrpSpPr>
        <p:grpSpPr>
          <a:xfrm flipV="1">
            <a:off x="9749685" y="3340649"/>
            <a:ext cx="2800952" cy="407840"/>
            <a:chOff x="8999621" y="5631544"/>
            <a:chExt cx="2438400" cy="1108992"/>
          </a:xfrm>
        </p:grpSpPr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B747D05A-6BD0-A053-B858-C159644F4B5D}"/>
                </a:ext>
              </a:extLst>
            </p:cNvPr>
            <p:cNvCxnSpPr/>
            <p:nvPr/>
          </p:nvCxnSpPr>
          <p:spPr>
            <a:xfrm>
              <a:off x="8999621" y="6192253"/>
              <a:ext cx="24384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直線矢印コネクタ 29">
              <a:extLst>
                <a:ext uri="{FF2B5EF4-FFF2-40B4-BE49-F238E27FC236}">
                  <a16:creationId xmlns:a16="http://schemas.microsoft.com/office/drawing/2014/main" id="{390D7065-9D38-B032-9582-0BE3AB53B75D}"/>
                </a:ext>
              </a:extLst>
            </p:cNvPr>
            <p:cNvCxnSpPr/>
            <p:nvPr/>
          </p:nvCxnSpPr>
          <p:spPr>
            <a:xfrm>
              <a:off x="8999621" y="6192253"/>
              <a:ext cx="0" cy="548283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直線矢印コネクタ 30">
              <a:extLst>
                <a:ext uri="{FF2B5EF4-FFF2-40B4-BE49-F238E27FC236}">
                  <a16:creationId xmlns:a16="http://schemas.microsoft.com/office/drawing/2014/main" id="{56C4359B-F9F9-FC32-4C8F-7D87A3FB8566}"/>
                </a:ext>
              </a:extLst>
            </p:cNvPr>
            <p:cNvCxnSpPr/>
            <p:nvPr/>
          </p:nvCxnSpPr>
          <p:spPr>
            <a:xfrm>
              <a:off x="11438021" y="6192253"/>
              <a:ext cx="0" cy="548283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415B8A4A-FBFB-0AF9-0657-7F237200FC75}"/>
                </a:ext>
              </a:extLst>
            </p:cNvPr>
            <p:cNvCxnSpPr/>
            <p:nvPr/>
          </p:nvCxnSpPr>
          <p:spPr>
            <a:xfrm flipV="1">
              <a:off x="10218051" y="5631544"/>
              <a:ext cx="0" cy="560708"/>
            </a:xfrm>
            <a:prstGeom prst="line">
              <a:avLst/>
            </a:prstGeom>
            <a:ln>
              <a:headEnd type="non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E5EE2B50-BE0A-B6C5-161C-DE1C11CDDDB5}"/>
              </a:ext>
            </a:extLst>
          </p:cNvPr>
          <p:cNvSpPr/>
          <p:nvPr/>
        </p:nvSpPr>
        <p:spPr>
          <a:xfrm>
            <a:off x="8730767" y="4819565"/>
            <a:ext cx="2049785" cy="8848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Chemotherapy</a:t>
            </a:r>
          </a:p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n = 41</a:t>
            </a: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668DE0C3-42AF-26AB-5E83-59BD11151099}"/>
              </a:ext>
            </a:extLst>
          </p:cNvPr>
          <p:cNvSpPr/>
          <p:nvPr/>
        </p:nvSpPr>
        <p:spPr>
          <a:xfrm>
            <a:off x="11536124" y="4823391"/>
            <a:ext cx="2014324" cy="8810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Radiation</a:t>
            </a:r>
          </a:p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n = 41</a:t>
            </a:r>
          </a:p>
        </p:txBody>
      </p: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8B12EF64-9742-D8B8-26B5-1FCE6AB944A2}"/>
              </a:ext>
            </a:extLst>
          </p:cNvPr>
          <p:cNvGrpSpPr/>
          <p:nvPr/>
        </p:nvGrpSpPr>
        <p:grpSpPr>
          <a:xfrm flipV="1">
            <a:off x="9778999" y="5716470"/>
            <a:ext cx="2800952" cy="407840"/>
            <a:chOff x="8999621" y="5631544"/>
            <a:chExt cx="2438400" cy="1108992"/>
          </a:xfrm>
        </p:grpSpPr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70B129EF-21D3-E3C0-C392-72D0ED0FEB3D}"/>
                </a:ext>
              </a:extLst>
            </p:cNvPr>
            <p:cNvCxnSpPr/>
            <p:nvPr/>
          </p:nvCxnSpPr>
          <p:spPr>
            <a:xfrm>
              <a:off x="8999621" y="6192253"/>
              <a:ext cx="24384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直線矢印コネクタ 36">
              <a:extLst>
                <a:ext uri="{FF2B5EF4-FFF2-40B4-BE49-F238E27FC236}">
                  <a16:creationId xmlns:a16="http://schemas.microsoft.com/office/drawing/2014/main" id="{1D85B8EE-E9DB-CA0A-766F-CFA49118356E}"/>
                </a:ext>
              </a:extLst>
            </p:cNvPr>
            <p:cNvCxnSpPr/>
            <p:nvPr/>
          </p:nvCxnSpPr>
          <p:spPr>
            <a:xfrm>
              <a:off x="8999621" y="6192253"/>
              <a:ext cx="0" cy="548283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直線矢印コネクタ 37">
              <a:extLst>
                <a:ext uri="{FF2B5EF4-FFF2-40B4-BE49-F238E27FC236}">
                  <a16:creationId xmlns:a16="http://schemas.microsoft.com/office/drawing/2014/main" id="{F2E55DE3-5539-9363-8A93-5FA55A848720}"/>
                </a:ext>
              </a:extLst>
            </p:cNvPr>
            <p:cNvCxnSpPr/>
            <p:nvPr/>
          </p:nvCxnSpPr>
          <p:spPr>
            <a:xfrm>
              <a:off x="11438021" y="6192253"/>
              <a:ext cx="0" cy="548283"/>
            </a:xfrm>
            <a:prstGeom prst="straightConnector1">
              <a:avLst/>
            </a:prstGeom>
            <a:ln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4A2FB2AB-7B85-8EB7-FF27-C4B7B7AC9654}"/>
                </a:ext>
              </a:extLst>
            </p:cNvPr>
            <p:cNvCxnSpPr/>
            <p:nvPr/>
          </p:nvCxnSpPr>
          <p:spPr>
            <a:xfrm flipV="1">
              <a:off x="10218051" y="5631544"/>
              <a:ext cx="0" cy="560708"/>
            </a:xfrm>
            <a:prstGeom prst="line">
              <a:avLst/>
            </a:prstGeom>
            <a:ln>
              <a:headEnd type="non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85F4D772-6750-B957-0F8A-FA8F707C4B66}"/>
              </a:ext>
            </a:extLst>
          </p:cNvPr>
          <p:cNvGrpSpPr/>
          <p:nvPr/>
        </p:nvGrpSpPr>
        <p:grpSpPr>
          <a:xfrm>
            <a:off x="9778999" y="4294214"/>
            <a:ext cx="2783198" cy="534520"/>
            <a:chOff x="8999621" y="5854912"/>
            <a:chExt cx="2438400" cy="885624"/>
          </a:xfrm>
        </p:grpSpPr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BD086AA0-3013-F083-CB56-17A9F8226159}"/>
                </a:ext>
              </a:extLst>
            </p:cNvPr>
            <p:cNvCxnSpPr/>
            <p:nvPr/>
          </p:nvCxnSpPr>
          <p:spPr>
            <a:xfrm>
              <a:off x="8999621" y="6192253"/>
              <a:ext cx="24384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直線矢印コネクタ 41">
              <a:extLst>
                <a:ext uri="{FF2B5EF4-FFF2-40B4-BE49-F238E27FC236}">
                  <a16:creationId xmlns:a16="http://schemas.microsoft.com/office/drawing/2014/main" id="{BD4BFA56-65E3-D31E-A50F-434845463867}"/>
                </a:ext>
              </a:extLst>
            </p:cNvPr>
            <p:cNvCxnSpPr/>
            <p:nvPr/>
          </p:nvCxnSpPr>
          <p:spPr>
            <a:xfrm>
              <a:off x="8999621" y="6192253"/>
              <a:ext cx="0" cy="54828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直線矢印コネクタ 42">
              <a:extLst>
                <a:ext uri="{FF2B5EF4-FFF2-40B4-BE49-F238E27FC236}">
                  <a16:creationId xmlns:a16="http://schemas.microsoft.com/office/drawing/2014/main" id="{86899FE7-CD21-C3DA-075B-419D407C311F}"/>
                </a:ext>
              </a:extLst>
            </p:cNvPr>
            <p:cNvCxnSpPr/>
            <p:nvPr/>
          </p:nvCxnSpPr>
          <p:spPr>
            <a:xfrm>
              <a:off x="11438021" y="6192253"/>
              <a:ext cx="0" cy="54828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C49C39B3-CE30-1DD8-926D-87D213E814D5}"/>
                </a:ext>
              </a:extLst>
            </p:cNvPr>
            <p:cNvCxnSpPr/>
            <p:nvPr/>
          </p:nvCxnSpPr>
          <p:spPr>
            <a:xfrm flipV="1">
              <a:off x="10220575" y="5854912"/>
              <a:ext cx="0" cy="354878"/>
            </a:xfrm>
            <a:prstGeom prst="line">
              <a:avLst/>
            </a:prstGeom>
            <a:ln>
              <a:head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6314DAC7-477B-8B4A-8995-134270A29504}"/>
              </a:ext>
            </a:extLst>
          </p:cNvPr>
          <p:cNvSpPr/>
          <p:nvPr/>
        </p:nvSpPr>
        <p:spPr>
          <a:xfrm>
            <a:off x="9610474" y="6119741"/>
            <a:ext cx="3194065" cy="5561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>
                <a:solidFill>
                  <a:schemeClr val="tx1"/>
                </a:solidFill>
              </a:rPr>
              <a:t>OS/PFS analysis</a:t>
            </a:r>
            <a:endParaRPr kumimoji="1" lang="ja-JP" altLang="en-US" sz="2400" dirty="0">
              <a:solidFill>
                <a:schemeClr val="tx1"/>
              </a:solidFill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18B3D4D3-D1BE-DAA8-9422-FE29D12EB22F}"/>
              </a:ext>
            </a:extLst>
          </p:cNvPr>
          <p:cNvSpPr txBox="1"/>
          <p:nvPr/>
        </p:nvSpPr>
        <p:spPr>
          <a:xfrm>
            <a:off x="149131" y="99586"/>
            <a:ext cx="10422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/>
              <a:t>Fig S6</a:t>
            </a:r>
            <a:endParaRPr kumimoji="1" lang="ja-JP" altLang="en-US" sz="2800" b="1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310C2F3-C3C7-6307-6AD9-29F5F604CACC}"/>
              </a:ext>
            </a:extLst>
          </p:cNvPr>
          <p:cNvSpPr txBox="1"/>
          <p:nvPr/>
        </p:nvSpPr>
        <p:spPr>
          <a:xfrm>
            <a:off x="1191404" y="1997214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A</a:t>
            </a:r>
            <a:endParaRPr kumimoji="1" lang="ja-JP" altLang="en-US" sz="2400" b="1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8C896C2-8095-8CC8-EE58-07397697E242}"/>
              </a:ext>
            </a:extLst>
          </p:cNvPr>
          <p:cNvSpPr txBox="1"/>
          <p:nvPr/>
        </p:nvSpPr>
        <p:spPr>
          <a:xfrm>
            <a:off x="7925532" y="1997213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B</a:t>
            </a:r>
            <a:endParaRPr kumimoji="1" lang="ja-JP" altLang="en-US" sz="2400" b="1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BAF3C46-337E-BE92-99CB-CF48DEAD606C}"/>
              </a:ext>
            </a:extLst>
          </p:cNvPr>
          <p:cNvSpPr txBox="1"/>
          <p:nvPr/>
        </p:nvSpPr>
        <p:spPr>
          <a:xfrm>
            <a:off x="2123956" y="8219847"/>
            <a:ext cx="1196094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6  Flowchart of study selection and statistical analyses </a:t>
            </a:r>
          </a:p>
          <a:p>
            <a:pPr algn="l"/>
            <a:r>
              <a:rPr lang="en-US" altLang="ja-JP" sz="2400" b="1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           </a:t>
            </a:r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 comparison between the radiation and chemotherapy groups in patients with </a:t>
            </a:r>
          </a:p>
          <a:p>
            <a:pPr algn="l"/>
            <a:r>
              <a:rPr lang="en-US" altLang="ja-JP" sz="2400" b="1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           </a:t>
            </a:r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A) tumor size ≥ 2cm and (B) tumor size &lt; 2cm</a:t>
            </a:r>
            <a:endParaRPr lang="ja-JP" altLang="ja-JP" sz="2400" b="1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64356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2" name="グラフ 51">
            <a:extLst>
              <a:ext uri="{FF2B5EF4-FFF2-40B4-BE49-F238E27FC236}">
                <a16:creationId xmlns:a16="http://schemas.microsoft.com/office/drawing/2014/main" id="{5C551BBB-6FA1-356C-1F5D-5A9989073E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4529100"/>
              </p:ext>
            </p:extLst>
          </p:nvPr>
        </p:nvGraphicFramePr>
        <p:xfrm>
          <a:off x="1191404" y="3272436"/>
          <a:ext cx="5784474" cy="35132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4" name="グラフ 53">
            <a:extLst>
              <a:ext uri="{FF2B5EF4-FFF2-40B4-BE49-F238E27FC236}">
                <a16:creationId xmlns:a16="http://schemas.microsoft.com/office/drawing/2014/main" id="{A2AB93D2-BEF6-1C32-1481-B2E0FA903F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0003662"/>
              </p:ext>
            </p:extLst>
          </p:nvPr>
        </p:nvGraphicFramePr>
        <p:xfrm>
          <a:off x="8094485" y="3272437"/>
          <a:ext cx="5784474" cy="35132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18B3D4D3-D1BE-DAA8-9422-FE29D12EB22F}"/>
              </a:ext>
            </a:extLst>
          </p:cNvPr>
          <p:cNvSpPr txBox="1"/>
          <p:nvPr/>
        </p:nvSpPr>
        <p:spPr>
          <a:xfrm>
            <a:off x="149131" y="99586"/>
            <a:ext cx="10422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/>
              <a:t>Fig S7</a:t>
            </a:r>
            <a:endParaRPr kumimoji="1" lang="ja-JP" altLang="en-US" sz="2800" b="1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310C2F3-C3C7-6307-6AD9-29F5F604CACC}"/>
              </a:ext>
            </a:extLst>
          </p:cNvPr>
          <p:cNvSpPr txBox="1"/>
          <p:nvPr/>
        </p:nvSpPr>
        <p:spPr>
          <a:xfrm>
            <a:off x="1191404" y="2109507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A</a:t>
            </a:r>
            <a:endParaRPr kumimoji="1" lang="ja-JP" altLang="en-US" sz="2400" b="1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8C896C2-8095-8CC8-EE58-07397697E242}"/>
              </a:ext>
            </a:extLst>
          </p:cNvPr>
          <p:cNvSpPr txBox="1"/>
          <p:nvPr/>
        </p:nvSpPr>
        <p:spPr>
          <a:xfrm>
            <a:off x="7688990" y="2109507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B</a:t>
            </a:r>
            <a:endParaRPr kumimoji="1" lang="ja-JP" altLang="en-US" sz="2400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D192D67-610A-6DFB-F720-2E9A540DC936}"/>
              </a:ext>
            </a:extLst>
          </p:cNvPr>
          <p:cNvSpPr txBox="1"/>
          <p:nvPr/>
        </p:nvSpPr>
        <p:spPr>
          <a:xfrm>
            <a:off x="1376711" y="8147552"/>
            <a:ext cx="1259512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. S7  Number of recurrent risk factors in (A) tumor size ≥ 2cm and (B) tumor size &lt; 2cm groups </a:t>
            </a:r>
          </a:p>
          <a:p>
            <a:pPr algn="l"/>
            <a:r>
              <a:rPr lang="en-US" altLang="ja-JP" sz="2400" b="1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           </a:t>
            </a:r>
            <a:r>
              <a:rPr lang="en-US" altLang="ja-JP" sz="24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fter propensity-matching</a:t>
            </a:r>
            <a:endParaRPr lang="ja-JP" altLang="ja-JP" sz="2400" b="1" kern="1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4888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824</TotalTime>
  <Words>376</Words>
  <Application>Microsoft Office PowerPoint</Application>
  <PresentationFormat>ユーザー設定</PresentationFormat>
  <Paragraphs>86</Paragraphs>
  <Slides>7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2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口 歩</dc:creator>
  <cp:lastModifiedBy>歩 田口</cp:lastModifiedBy>
  <cp:revision>28</cp:revision>
  <dcterms:created xsi:type="dcterms:W3CDTF">2022-08-15T21:52:21Z</dcterms:created>
  <dcterms:modified xsi:type="dcterms:W3CDTF">2023-05-26T13:10:13Z</dcterms:modified>
</cp:coreProperties>
</file>